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66"/>
    <a:srgbClr val="385723"/>
    <a:srgbClr val="A9D18E"/>
    <a:srgbClr val="009900"/>
    <a:srgbClr val="92D050"/>
    <a:srgbClr val="336699"/>
    <a:srgbClr val="0066CC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0078DCD-5234-4C18-BFD0-5B2000875275}" v="27" dt="2021-10-03T16:12:02.2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7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2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is Hoyer" userId="8c378a1a5b622d94" providerId="LiveId" clId="{20078DCD-5234-4C18-BFD0-5B2000875275}"/>
    <pc:docChg chg="modSld">
      <pc:chgData name="Lois Hoyer" userId="8c378a1a5b622d94" providerId="LiveId" clId="{20078DCD-5234-4C18-BFD0-5B2000875275}" dt="2021-10-03T16:17:04.459" v="237" actId="20577"/>
      <pc:docMkLst>
        <pc:docMk/>
      </pc:docMkLst>
      <pc:sldChg chg="modSp mod">
        <pc:chgData name="Lois Hoyer" userId="8c378a1a5b622d94" providerId="LiveId" clId="{20078DCD-5234-4C18-BFD0-5B2000875275}" dt="2021-09-28T14:53:07.815" v="73" actId="1035"/>
        <pc:sldMkLst>
          <pc:docMk/>
          <pc:sldMk cId="380902020" sldId="256"/>
        </pc:sldMkLst>
        <pc:spChg chg="mod">
          <ac:chgData name="Lois Hoyer" userId="8c378a1a5b622d94" providerId="LiveId" clId="{20078DCD-5234-4C18-BFD0-5B2000875275}" dt="2021-09-28T14:49:49.040" v="2" actId="1076"/>
          <ac:spMkLst>
            <pc:docMk/>
            <pc:sldMk cId="380902020" sldId="256"/>
            <ac:spMk id="4" creationId="{2647DDF4-759B-481A-ABF3-7AA8F7097C11}"/>
          </ac:spMkLst>
        </pc:spChg>
        <pc:spChg chg="mod">
          <ac:chgData name="Lois Hoyer" userId="8c378a1a5b622d94" providerId="LiveId" clId="{20078DCD-5234-4C18-BFD0-5B2000875275}" dt="2021-09-28T14:51:02.138" v="49" actId="1035"/>
          <ac:spMkLst>
            <pc:docMk/>
            <pc:sldMk cId="380902020" sldId="256"/>
            <ac:spMk id="48" creationId="{E1CC8FBC-C940-4F8C-8B1D-269BFBEAFAB5}"/>
          </ac:spMkLst>
        </pc:spChg>
        <pc:spChg chg="mod">
          <ac:chgData name="Lois Hoyer" userId="8c378a1a5b622d94" providerId="LiveId" clId="{20078DCD-5234-4C18-BFD0-5B2000875275}" dt="2021-09-28T14:52:47.293" v="63" actId="1035"/>
          <ac:spMkLst>
            <pc:docMk/>
            <pc:sldMk cId="380902020" sldId="256"/>
            <ac:spMk id="108" creationId="{C2E800E5-18F0-4F7A-B242-6362919FEE90}"/>
          </ac:spMkLst>
        </pc:spChg>
        <pc:spChg chg="mod">
          <ac:chgData name="Lois Hoyer" userId="8c378a1a5b622d94" providerId="LiveId" clId="{20078DCD-5234-4C18-BFD0-5B2000875275}" dt="2021-09-28T14:52:25.223" v="61" actId="20577"/>
          <ac:spMkLst>
            <pc:docMk/>
            <pc:sldMk cId="380902020" sldId="256"/>
            <ac:spMk id="145" creationId="{56603B88-69D2-4969-A0F8-CF996CB13C03}"/>
          </ac:spMkLst>
        </pc:spChg>
        <pc:spChg chg="mod">
          <ac:chgData name="Lois Hoyer" userId="8c378a1a5b622d94" providerId="LiveId" clId="{20078DCD-5234-4C18-BFD0-5B2000875275}" dt="2021-09-28T14:52:55.997" v="68" actId="1035"/>
          <ac:spMkLst>
            <pc:docMk/>
            <pc:sldMk cId="380902020" sldId="256"/>
            <ac:spMk id="150" creationId="{642E4670-D655-4667-8EF3-2CA0B091D272}"/>
          </ac:spMkLst>
        </pc:spChg>
        <pc:spChg chg="mod">
          <ac:chgData name="Lois Hoyer" userId="8c378a1a5b622d94" providerId="LiveId" clId="{20078DCD-5234-4C18-BFD0-5B2000875275}" dt="2021-09-28T14:53:07.815" v="73" actId="1035"/>
          <ac:spMkLst>
            <pc:docMk/>
            <pc:sldMk cId="380902020" sldId="256"/>
            <ac:spMk id="153" creationId="{E9A8B4C2-FB7A-42C2-ACDB-5311A47FA03D}"/>
          </ac:spMkLst>
        </pc:spChg>
        <pc:spChg chg="mod">
          <ac:chgData name="Lois Hoyer" userId="8c378a1a5b622d94" providerId="LiveId" clId="{20078DCD-5234-4C18-BFD0-5B2000875275}" dt="2021-09-28T14:52:52.061" v="65" actId="1035"/>
          <ac:spMkLst>
            <pc:docMk/>
            <pc:sldMk cId="380902020" sldId="256"/>
            <ac:spMk id="203" creationId="{93E89B22-0875-45B9-BCDA-AAF3EEF95246}"/>
          </ac:spMkLst>
        </pc:spChg>
        <pc:grpChg chg="mod">
          <ac:chgData name="Lois Hoyer" userId="8c378a1a5b622d94" providerId="LiveId" clId="{20078DCD-5234-4C18-BFD0-5B2000875275}" dt="2021-09-28T14:49:49.040" v="2" actId="1076"/>
          <ac:grpSpMkLst>
            <pc:docMk/>
            <pc:sldMk cId="380902020" sldId="256"/>
            <ac:grpSpMk id="2" creationId="{FD9BFED8-B2A7-4371-8BCA-CFD40C366BB7}"/>
          </ac:grpSpMkLst>
        </pc:grpChg>
        <pc:grpChg chg="mod">
          <ac:chgData name="Lois Hoyer" userId="8c378a1a5b622d94" providerId="LiveId" clId="{20078DCD-5234-4C18-BFD0-5B2000875275}" dt="2021-09-28T14:51:07.666" v="50" actId="1076"/>
          <ac:grpSpMkLst>
            <pc:docMk/>
            <pc:sldMk cId="380902020" sldId="256"/>
            <ac:grpSpMk id="3" creationId="{F407066C-1A68-42C3-B65F-A6210FFD18CD}"/>
          </ac:grpSpMkLst>
        </pc:grpChg>
        <pc:grpChg chg="mod">
          <ac:chgData name="Lois Hoyer" userId="8c378a1a5b622d94" providerId="LiveId" clId="{20078DCD-5234-4C18-BFD0-5B2000875275}" dt="2021-09-28T14:49:56.932" v="3" actId="1076"/>
          <ac:grpSpMkLst>
            <pc:docMk/>
            <pc:sldMk cId="380902020" sldId="256"/>
            <ac:grpSpMk id="30" creationId="{59974464-85BF-4075-A9F2-C451931C68F5}"/>
          </ac:grpSpMkLst>
        </pc:grpChg>
        <pc:grpChg chg="mod">
          <ac:chgData name="Lois Hoyer" userId="8c378a1a5b622d94" providerId="LiveId" clId="{20078DCD-5234-4C18-BFD0-5B2000875275}" dt="2021-09-28T14:51:02.138" v="49" actId="1035"/>
          <ac:grpSpMkLst>
            <pc:docMk/>
            <pc:sldMk cId="380902020" sldId="256"/>
            <ac:grpSpMk id="31" creationId="{B6C10140-F0CB-43E0-A406-1384C312F7DB}"/>
          </ac:grpSpMkLst>
        </pc:grpChg>
        <pc:grpChg chg="mod">
          <ac:chgData name="Lois Hoyer" userId="8c378a1a5b622d94" providerId="LiveId" clId="{20078DCD-5234-4C18-BFD0-5B2000875275}" dt="2021-09-28T14:52:55.997" v="68" actId="1035"/>
          <ac:grpSpMkLst>
            <pc:docMk/>
            <pc:sldMk cId="380902020" sldId="256"/>
            <ac:grpSpMk id="32" creationId="{CA8D5CBB-B822-46AF-9413-8FFC0CAFF519}"/>
          </ac:grpSpMkLst>
        </pc:grpChg>
        <pc:grpChg chg="mod">
          <ac:chgData name="Lois Hoyer" userId="8c378a1a5b622d94" providerId="LiveId" clId="{20078DCD-5234-4C18-BFD0-5B2000875275}" dt="2021-09-28T14:52:47.293" v="63" actId="1035"/>
          <ac:grpSpMkLst>
            <pc:docMk/>
            <pc:sldMk cId="380902020" sldId="256"/>
            <ac:grpSpMk id="109" creationId="{42626F29-34EA-4617-990F-4480F523F858}"/>
          </ac:grpSpMkLst>
        </pc:grpChg>
        <pc:grpChg chg="mod">
          <ac:chgData name="Lois Hoyer" userId="8c378a1a5b622d94" providerId="LiveId" clId="{20078DCD-5234-4C18-BFD0-5B2000875275}" dt="2021-09-28T14:52:52.061" v="65" actId="1035"/>
          <ac:grpSpMkLst>
            <pc:docMk/>
            <pc:sldMk cId="380902020" sldId="256"/>
            <ac:grpSpMk id="198" creationId="{486EEAA0-35A4-4754-A53E-3780B7BFE388}"/>
          </ac:grpSpMkLst>
        </pc:grpChg>
      </pc:sldChg>
      <pc:sldChg chg="modSp mod">
        <pc:chgData name="Lois Hoyer" userId="8c378a1a5b622d94" providerId="LiveId" clId="{20078DCD-5234-4C18-BFD0-5B2000875275}" dt="2021-10-03T16:17:04.459" v="237" actId="20577"/>
        <pc:sldMkLst>
          <pc:docMk/>
          <pc:sldMk cId="4087375386" sldId="257"/>
        </pc:sldMkLst>
        <pc:spChg chg="mod">
          <ac:chgData name="Lois Hoyer" userId="8c378a1a5b622d94" providerId="LiveId" clId="{20078DCD-5234-4C18-BFD0-5B2000875275}" dt="2021-10-03T16:17:04.459" v="237" actId="20577"/>
          <ac:spMkLst>
            <pc:docMk/>
            <pc:sldMk cId="4087375386" sldId="257"/>
            <ac:spMk id="5" creationId="{81186539-15B9-4DDE-A189-A5C18B4FEAFD}"/>
          </ac:spMkLst>
        </pc:spChg>
      </pc:sldChg>
    </pc:docChg>
  </pc:docChgLst>
  <pc:docChgLst>
    <pc:chgData name="Lois Hoyer" userId="8c378a1a5b622d94" providerId="LiveId" clId="{F3D1B856-724C-4300-8492-659BEC7107D9}"/>
    <pc:docChg chg="undo custSel addSld modSld">
      <pc:chgData name="Lois Hoyer" userId="8c378a1a5b622d94" providerId="LiveId" clId="{F3D1B856-724C-4300-8492-659BEC7107D9}" dt="2021-09-21T16:18:00.257" v="3828" actId="20577"/>
      <pc:docMkLst>
        <pc:docMk/>
      </pc:docMkLst>
      <pc:sldChg chg="addSp delSp modSp mod">
        <pc:chgData name="Lois Hoyer" userId="8c378a1a5b622d94" providerId="LiveId" clId="{F3D1B856-724C-4300-8492-659BEC7107D9}" dt="2021-09-20T21:05:23.998" v="3823" actId="20577"/>
        <pc:sldMkLst>
          <pc:docMk/>
          <pc:sldMk cId="380902020" sldId="256"/>
        </pc:sldMkLst>
        <pc:spChg chg="mod topLvl">
          <ac:chgData name="Lois Hoyer" userId="8c378a1a5b622d94" providerId="LiveId" clId="{F3D1B856-724C-4300-8492-659BEC7107D9}" dt="2021-09-16T20:12:28.877" v="2903" actId="1035"/>
          <ac:spMkLst>
            <pc:docMk/>
            <pc:sldMk cId="380902020" sldId="256"/>
            <ac:spMk id="4" creationId="{2647DDF4-759B-481A-ABF3-7AA8F7097C11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" creationId="{64C3A0DE-2C91-4535-AF7A-394814E83416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6" creationId="{2C30B5B3-7C20-4A72-AE5A-16CC182652B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7" creationId="{1788274D-7DAA-4CB4-B7FC-0D3AC7589C34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8" creationId="{3584E819-1072-44B5-AD29-2BC2E3E3F614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9" creationId="{0EA8121A-2563-4FAB-9306-905C2FBAE103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0" creationId="{671991C7-55BE-4B38-8499-4BC83CF330C2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1" creationId="{C53B7DEB-0242-4DA1-AD1A-18B89AB23B1B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2" creationId="{17A22548-54DF-40F4-84DC-95AB081A9103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3" creationId="{57EC84E6-98DA-45C6-8227-41F49A2CD02A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4" creationId="{DFD0AC64-0912-458A-B668-81CE91F1BF25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" creationId="{14076AB1-52D6-41EC-ACB9-9146159F994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" creationId="{26159DAA-3378-4CFD-B48B-4085884F2CA5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7" creationId="{8B6CEA89-DEA2-4B7D-852D-630D11CF0599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8" creationId="{2B03AF00-5801-4B5C-9D1A-9B510178875B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9" creationId="{8ED943C0-4F00-4CE1-8CE0-E8D84A631131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0" creationId="{B6234098-4491-4151-8F6D-6566CCD8E1E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1" creationId="{CF4C54DE-4B3F-4AC3-AB9C-C14045395109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2" creationId="{8AB1D928-8435-4347-AA6F-5EAD0778F64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3" creationId="{AE88B02D-1F58-4D12-9B2F-104DE09B04E1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4" creationId="{2C365E4A-95A8-458B-A2ED-9C4B6A172947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5" creationId="{674B89E5-5CA4-44B1-925B-516FC21D429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6" creationId="{DCD11C46-4AD5-4580-B4DA-978CCC459D5A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7" creationId="{02795E41-B6F1-4E3F-B02D-BA18EC34DE78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8" creationId="{35E50ACA-C8DC-408A-9A4F-E42555A36035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29" creationId="{F0C53207-1C06-4CAF-9368-D198DD1B2D26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0" creationId="{2A64D5B1-0F40-4700-BB87-3277C3CC7364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1" creationId="{E545F580-95A5-4DA5-9676-9FEBAE0444BC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2" creationId="{E927BF54-6C30-460E-A4F0-208CDB67FE9E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3" creationId="{0A015689-3468-4E81-A48D-555E51C647F9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4" creationId="{5581D6BD-69D7-46ED-9B95-3B84806E3C35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35" creationId="{12D30921-7CB7-42A4-9256-404970B5B152}"/>
          </ac:spMkLst>
        </pc:spChg>
        <pc:spChg chg="del mod topLvl">
          <ac:chgData name="Lois Hoyer" userId="8c378a1a5b622d94" providerId="LiveId" clId="{F3D1B856-724C-4300-8492-659BEC7107D9}" dt="2021-09-09T14:27:51.220" v="218" actId="478"/>
          <ac:spMkLst>
            <pc:docMk/>
            <pc:sldMk cId="380902020" sldId="256"/>
            <ac:spMk id="36" creationId="{5C807E02-4C81-4914-8CFA-988742247FA7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7" creationId="{B1B5C760-FD2D-4D15-ACFA-2025FB0FE91E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8" creationId="{4A25A915-E48D-4428-AD4D-9972145DC0DE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39" creationId="{57B92455-0D78-43CE-8803-F04E921A4F8A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40" creationId="{ED77AD38-6AF4-4219-A01E-E9B07CC1DA30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41" creationId="{4AFC4CA9-AD5F-472A-971A-1CA4B23C367E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42" creationId="{C7E7A64E-6CC6-47A2-8B58-EEDE52FE46A7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43" creationId="{5B806C55-6CAB-4C17-8C05-9B7D8EE20487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44" creationId="{E1F38D94-51CF-4B8F-82CF-B18F4A0FEA9A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45" creationId="{90D3B040-D604-43FD-9575-738BF018FB6E}"/>
          </ac:spMkLst>
        </pc:spChg>
        <pc:spChg chg="del mod topLvl">
          <ac:chgData name="Lois Hoyer" userId="8c378a1a5b622d94" providerId="LiveId" clId="{F3D1B856-724C-4300-8492-659BEC7107D9}" dt="2021-09-09T14:27:55.693" v="219" actId="478"/>
          <ac:spMkLst>
            <pc:docMk/>
            <pc:sldMk cId="380902020" sldId="256"/>
            <ac:spMk id="46" creationId="{0E18AE9F-10C1-4E5E-A44D-72DE10AAB00D}"/>
          </ac:spMkLst>
        </pc:spChg>
        <pc:spChg chg="del mod topLvl">
          <ac:chgData name="Lois Hoyer" userId="8c378a1a5b622d94" providerId="LiveId" clId="{F3D1B856-724C-4300-8492-659BEC7107D9}" dt="2021-09-16T20:12:16.388" v="2851" actId="21"/>
          <ac:spMkLst>
            <pc:docMk/>
            <pc:sldMk cId="380902020" sldId="256"/>
            <ac:spMk id="47" creationId="{B2E83ED4-51E8-4843-9413-0A607B240438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48" creationId="{E1CC8FBC-C940-4F8C-8B1D-269BFBEAFAB5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49" creationId="{816331E3-6B3E-4988-B5ED-58D0F087754D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0" creationId="{F8F2B976-4AE0-4D48-B594-8DF1973FFB2D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1" creationId="{0BAED963-EA20-4AA5-BB2C-7D6D04A30C4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2" creationId="{851B09DB-0EE1-4757-B28A-266226E3369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3" creationId="{F619A7EB-4154-4B8D-9DBD-65AA491B3089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4" creationId="{C2F67B9D-1FD1-4AF6-9F41-51BDA8E02D83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5" creationId="{84B27E5B-4DB8-4C6D-8824-BF1DE52CD93C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56" creationId="{20511B62-BD14-4229-8F45-9C9379B13F6B}"/>
          </ac:spMkLst>
        </pc:spChg>
        <pc:spChg chg="del mod topLvl">
          <ac:chgData name="Lois Hoyer" userId="8c378a1a5b622d94" providerId="LiveId" clId="{F3D1B856-724C-4300-8492-659BEC7107D9}" dt="2021-09-09T16:30:50.274" v="792" actId="478"/>
          <ac:spMkLst>
            <pc:docMk/>
            <pc:sldMk cId="380902020" sldId="256"/>
            <ac:spMk id="57" creationId="{96C20C2A-8C3A-49D6-8B27-28B5F54E57F0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58" creationId="{60D80F0D-1204-47FF-8213-3CC400B614CE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59" creationId="{71C7E459-A645-4234-9D9C-88AF15417D0C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0" creationId="{26B8D77D-6694-49DE-B321-C04CB6BFAEFC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1" creationId="{8D648E33-59A1-4520-B546-50363BC0D7FE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2" creationId="{96DEB5E0-377A-4404-B038-519D9CDE22B3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3" creationId="{0640907E-9269-4BF2-80F6-BB82EBF37CB1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4" creationId="{3302CAD9-271F-42EB-A600-7E6ED2CA0B47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5" creationId="{756B6C94-39A7-4DF0-BD89-C2B7485C3688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6" creationId="{434FB8AB-15AC-4792-94C1-B518E9EB2B97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7" creationId="{6579CA24-4D39-4D13-9052-1069B15BC590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8" creationId="{41F16969-6017-49A4-8D9F-AE691C6F0E66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69" creationId="{F687A96F-8DBB-4F0C-8A75-7210BECB58C0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0" creationId="{7C73FD2F-92A5-43E6-84E5-D555DDC8BDA2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1" creationId="{A0BA3036-A571-4CC6-8C1A-A6D46C347849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2" creationId="{25D4EAB3-4275-4CD7-8436-5847D853BF0E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3" creationId="{E8B80CFE-6ADB-4B28-A55F-E206D28CFE6D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4" creationId="{E8F6A316-E6F2-4B0D-B30C-6370938FA7F2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5" creationId="{A05CC0FD-DDE9-463C-868E-DCE16D963B6B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6" creationId="{260966ED-EA91-4993-AD3F-149069F4EBAA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7" creationId="{D928C57D-C42A-41A2-BF98-071C64A7286E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8" creationId="{6933330D-4E50-4A3C-8E7A-233FB407868E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79" creationId="{0E3D681E-AE3C-4251-ABC7-4511E4A2620D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0" creationId="{2EED958C-125A-44D0-A8F6-F7A63AE0D8E3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1" creationId="{DE1AB3D8-0DC3-48C4-9A97-392F16653661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2" creationId="{9B167F42-ADE6-433E-9023-B58B4F15AB46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3" creationId="{01B73892-CE4B-491C-8703-971A718DFB4F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4" creationId="{142C2008-48C7-4489-831D-D57D1A81E0CA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5" creationId="{D987FC38-AE6F-4ED7-A814-4FB1FDC23BC9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6" creationId="{7C10356F-A067-438C-871A-5A69FA251C75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7" creationId="{A82104CA-CA6F-4644-BEE3-B9D187CCE7DD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8" creationId="{41AA6EFC-E493-4860-8FE6-504B0853E6F9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89" creationId="{C65A2AD6-32E1-4299-9C94-D1C21D3F3177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0" creationId="{1D416637-0704-4752-8F6C-9F11093F5B1F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1" creationId="{6C305552-993E-4B1C-BE20-7B8FCE9BC2CD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2" creationId="{0A97F099-E052-4A52-8D14-946C5D91E1F6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3" creationId="{7EE6519B-8DDE-4E16-8C85-0AD7D6A4C8D0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4" creationId="{E79F9B98-771F-40CA-BF41-9A788046639F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5" creationId="{4E298672-0C5F-43C7-B012-9813D3B69742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6" creationId="{9DEE6D81-D2C4-4171-B9D2-260852A4F560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7" creationId="{98683610-F16C-40DF-A175-7F34B217B41C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8" creationId="{95E0C0D7-D2CE-47F9-9265-5D1365DDE21C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99" creationId="{91A81DE8-12E8-4A60-9897-3118C7272438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0" creationId="{667B24FF-C2EA-4A02-8C2C-3A08434470A7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1" creationId="{2880956F-F11E-4718-8A2F-83F9B33729D8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2" creationId="{7D555809-E7EC-4BAD-B7BD-D1DE75CF431A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3" creationId="{58140FE2-B576-4DD7-B2ED-F25B47B0AE22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4" creationId="{56D9121C-706B-4EFF-AD26-227683EFDAC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05" creationId="{A2AA0264-C7D1-4ACF-A221-282AA2F559EA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06" creationId="{2C123B1D-0338-43D4-BC45-69F34A39C846}"/>
          </ac:spMkLst>
        </pc:spChg>
        <pc:spChg chg="add mod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07" creationId="{A60E0FA3-0B4D-4DA5-964C-692F8AAF368C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7" creationId="{B3576BDC-C3F2-4F94-9E02-55386B72BCC6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8" creationId="{1F7A20F3-362B-45B6-99B7-824996B6AC29}"/>
          </ac:spMkLst>
        </pc:spChg>
        <pc:spChg chg="add mod">
          <ac:chgData name="Lois Hoyer" userId="8c378a1a5b622d94" providerId="LiveId" clId="{F3D1B856-724C-4300-8492-659BEC7107D9}" dt="2021-09-16T20:12:40.396" v="2905" actId="1076"/>
          <ac:spMkLst>
            <pc:docMk/>
            <pc:sldMk cId="380902020" sldId="256"/>
            <ac:spMk id="108" creationId="{C2E800E5-18F0-4F7A-B242-6362919FEE90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09" creationId="{11DDFB9B-845C-469C-8B0C-983E5CD6E2FE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10" creationId="{004F98B7-8556-4B59-8FE0-C4FF329C8079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10" creationId="{D0A22F11-304B-45B9-9CDF-F1917128620A}"/>
          </ac:spMkLst>
        </pc:spChg>
        <pc:spChg chg="add mod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11" creationId="{2D344960-4AA2-4E59-A915-CBBBA36A0501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11" creationId="{B34DBF0E-4585-4834-9542-E3582A1123CF}"/>
          </ac:spMkLst>
        </pc:spChg>
        <pc:spChg chg="add mod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12" creationId="{4052B38A-2EA5-4146-8369-6C248E35A34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12" creationId="{9D315F3E-64AF-4B9C-8E62-2D9DFEA212E6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13" creationId="{373ABBC9-63F7-46D4-8610-DC337290A6AA}"/>
          </ac:spMkLst>
        </pc:spChg>
        <pc:spChg chg="del mod topLvl">
          <ac:chgData name="Lois Hoyer" userId="8c378a1a5b622d94" providerId="LiveId" clId="{F3D1B856-724C-4300-8492-659BEC7107D9}" dt="2021-09-09T16:40:10.527" v="872" actId="478"/>
          <ac:spMkLst>
            <pc:docMk/>
            <pc:sldMk cId="380902020" sldId="256"/>
            <ac:spMk id="113" creationId="{94EF5E3A-26EF-47F2-B653-30947D82AD57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14" creationId="{7E0F1560-C29E-4073-9F75-68ACF0D10CE8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15" creationId="{A4120B7B-1062-48A4-92B0-A6B7DE0A752D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16" creationId="{84B325BC-23BA-42AC-A61B-F5BA8E08D919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17" creationId="{AD3045DA-26B3-416D-B589-425D37751EEF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18" creationId="{45FED51F-C253-4509-BE45-D5C169B53156}"/>
          </ac:spMkLst>
        </pc:spChg>
        <pc:spChg chg="del mod topLvl">
          <ac:chgData name="Lois Hoyer" userId="8c378a1a5b622d94" providerId="LiveId" clId="{F3D1B856-724C-4300-8492-659BEC7107D9}" dt="2021-09-20T20:30:55.141" v="2981" actId="21"/>
          <ac:spMkLst>
            <pc:docMk/>
            <pc:sldMk cId="380902020" sldId="256"/>
            <ac:spMk id="119" creationId="{A64CD0E0-ECF7-4C99-B223-47ED965E18F2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20" creationId="{BD5B035F-0678-4F40-91E5-D65C0342FA01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21" creationId="{4A7708C6-7334-4D20-AECE-8C59EAB423E8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22" creationId="{5A631DE6-4F56-485D-BDA2-89B41F74FC87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23" creationId="{77122AB3-B699-4E31-8495-4BBF6D32F44F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24" creationId="{3D6BAD10-97E9-45DE-8BBA-B3937CB27DD6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25" creationId="{9C6E7825-36E3-4C31-9FDF-7C6C07353111}"/>
          </ac:spMkLst>
        </pc:spChg>
        <pc:spChg chg="del mod topLvl">
          <ac:chgData name="Lois Hoyer" userId="8c378a1a5b622d94" providerId="LiveId" clId="{F3D1B856-724C-4300-8492-659BEC7107D9}" dt="2021-09-20T20:30:55.141" v="2981" actId="21"/>
          <ac:spMkLst>
            <pc:docMk/>
            <pc:sldMk cId="380902020" sldId="256"/>
            <ac:spMk id="126" creationId="{C76E54CF-1C0A-4456-BCF5-DB83573196F2}"/>
          </ac:spMkLst>
        </pc:spChg>
        <pc:spChg chg="del mod">
          <ac:chgData name="Lois Hoyer" userId="8c378a1a5b622d94" providerId="LiveId" clId="{F3D1B856-724C-4300-8492-659BEC7107D9}" dt="2021-09-20T20:36:04.980" v="3055" actId="21"/>
          <ac:spMkLst>
            <pc:docMk/>
            <pc:sldMk cId="380902020" sldId="256"/>
            <ac:spMk id="127" creationId="{9236DBB7-5FA7-4F53-8055-CE02AC8180F2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28" creationId="{824E47CC-CB90-4275-94FC-18A57D89BF2E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29" creationId="{57130DC9-C168-406B-A671-4A916B5EE5CF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30" creationId="{D6F8BF60-A1E7-43DB-B7B9-ABA883130456}"/>
          </ac:spMkLst>
        </pc:spChg>
        <pc:spChg chg="mod topLvl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31" creationId="{87AB9E63-6A40-4ED1-B3AC-0A4639DEBB54}"/>
          </ac:spMkLst>
        </pc:spChg>
        <pc:spChg chg="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32" creationId="{E2D503D4-FFBC-4F82-A622-5DE3F7798A70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33" creationId="{14FB80F4-E151-4512-A8CA-1AF79A652019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34" creationId="{4AC519ED-769A-4C48-91AC-327A65ADCF26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35" creationId="{13147A75-5752-497D-8230-D359D6D5F709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36" creationId="{60611EBA-8ED4-436F-BA86-886265C1B901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37" creationId="{978F2004-693F-48DF-95BE-F3A30D21CE77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38" creationId="{6B2C83B1-52E2-454F-9CB0-46A76FFD37FA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39" creationId="{D2D7F561-8BD9-44C6-ADCB-D5B9267A1D44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40" creationId="{FEBBC7D6-FC15-4FD5-BE2A-CC7CF810B03B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41" creationId="{CB964D13-9C3C-48D7-B751-AFB0DC26D5DE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42" creationId="{C8A5A13C-4D25-433E-8B33-CEEF33EC1A38}"/>
          </ac:spMkLst>
        </pc:spChg>
        <pc:spChg chg="add 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43" creationId="{57EE8AD8-682C-41DC-84B7-B4183DA35F7A}"/>
          </ac:spMkLst>
        </pc:spChg>
        <pc:spChg chg="add 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44" creationId="{A779600B-0180-4187-8503-86391BD8CA1E}"/>
          </ac:spMkLst>
        </pc:spChg>
        <pc:spChg chg="mod">
          <ac:chgData name="Lois Hoyer" userId="8c378a1a5b622d94" providerId="LiveId" clId="{F3D1B856-724C-4300-8492-659BEC7107D9}" dt="2021-09-20T21:05:23.998" v="3823" actId="20577"/>
          <ac:spMkLst>
            <pc:docMk/>
            <pc:sldMk cId="380902020" sldId="256"/>
            <ac:spMk id="145" creationId="{56603B88-69D2-4969-A0F8-CF996CB13C03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46" creationId="{3DA3AD4D-E025-48DF-A719-8ABC9F27E914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47" creationId="{F0ECB918-04C8-4702-8F17-F5DC46B29AF7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48" creationId="{F8C084B1-4A95-4479-9509-E012CDD039DB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49" creationId="{581D53A7-8D5B-4BCB-A892-AD6878A00F0B}"/>
          </ac:spMkLst>
        </pc:spChg>
        <pc:spChg chg="add mod topLvl">
          <ac:chgData name="Lois Hoyer" userId="8c378a1a5b622d94" providerId="LiveId" clId="{F3D1B856-724C-4300-8492-659BEC7107D9}" dt="2021-09-16T20:13:05.013" v="2941" actId="1036"/>
          <ac:spMkLst>
            <pc:docMk/>
            <pc:sldMk cId="380902020" sldId="256"/>
            <ac:spMk id="150" creationId="{642E4670-D655-4667-8EF3-2CA0B091D272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1" creationId="{4656701D-530B-4AB5-A25C-98EBA93E24E2}"/>
          </ac:spMkLst>
        </pc:spChg>
        <pc:spChg chg="add mod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51" creationId="{8D569C21-E241-454F-86CF-302C3CBAE115}"/>
          </ac:spMkLst>
        </pc:spChg>
        <pc:spChg chg="add mod">
          <ac:chgData name="Lois Hoyer" userId="8c378a1a5b622d94" providerId="LiveId" clId="{F3D1B856-724C-4300-8492-659BEC7107D9}" dt="2021-09-20T20:37:24.825" v="3088" actId="1037"/>
          <ac:spMkLst>
            <pc:docMk/>
            <pc:sldMk cId="380902020" sldId="256"/>
            <ac:spMk id="152" creationId="{339F0320-F529-4593-BE4A-0006C62B201A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2" creationId="{EBB68CE3-BC35-4632-BD93-803C735D8981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3" creationId="{2030AB42-FB0F-4A1A-91FC-1900B8BF2E74}"/>
          </ac:spMkLst>
        </pc:spChg>
        <pc:spChg chg="add mod">
          <ac:chgData name="Lois Hoyer" userId="8c378a1a5b622d94" providerId="LiveId" clId="{F3D1B856-724C-4300-8492-659BEC7107D9}" dt="2021-09-20T20:37:14.526" v="3079" actId="1076"/>
          <ac:spMkLst>
            <pc:docMk/>
            <pc:sldMk cId="380902020" sldId="256"/>
            <ac:spMk id="153" creationId="{E9A8B4C2-FB7A-42C2-ACDB-5311A47FA03D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4" creationId="{8B21018E-7B08-498C-BA99-373933E223D5}"/>
          </ac:spMkLst>
        </pc:spChg>
        <pc:spChg chg="add mod">
          <ac:chgData name="Lois Hoyer" userId="8c378a1a5b622d94" providerId="LiveId" clId="{F3D1B856-724C-4300-8492-659BEC7107D9}" dt="2021-09-20T20:36:54.344" v="3074" actId="1076"/>
          <ac:spMkLst>
            <pc:docMk/>
            <pc:sldMk cId="380902020" sldId="256"/>
            <ac:spMk id="154" creationId="{C7850551-5BA4-41FE-B9CD-332566131064}"/>
          </ac:spMkLst>
        </pc:spChg>
        <pc:spChg chg="add del mod topLvl">
          <ac:chgData name="Lois Hoyer" userId="8c378a1a5b622d94" providerId="LiveId" clId="{F3D1B856-724C-4300-8492-659BEC7107D9}" dt="2021-09-16T20:12:57.028" v="2906" actId="21"/>
          <ac:spMkLst>
            <pc:docMk/>
            <pc:sldMk cId="380902020" sldId="256"/>
            <ac:spMk id="155" creationId="{DDE81840-E66A-4D52-BAB3-6305A082C7E6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6" creationId="{047EB868-F1DE-45EC-89CA-045CB8C1819C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7" creationId="{7098962D-3B7D-4AC4-885A-B0590B9B5659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8" creationId="{02C6F2B2-DB64-46B6-BB7E-480130387500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59" creationId="{ED496C2D-6D20-4D7A-A030-7F0435752A87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0" creationId="{A2D15B17-7F3E-4243-8B6A-476754B53A80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1" creationId="{B1276F1B-5C4C-429F-8506-5D86DD66F9A8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62" creationId="{1B90E1D6-DDE3-4DF7-B996-EEA5B7A5A2FB}"/>
          </ac:spMkLst>
        </pc:spChg>
        <pc:spChg chg="add del mod">
          <ac:chgData name="Lois Hoyer" userId="8c378a1a5b622d94" providerId="LiveId" clId="{F3D1B856-724C-4300-8492-659BEC7107D9}" dt="2021-09-09T16:32:02.550" v="808" actId="478"/>
          <ac:spMkLst>
            <pc:docMk/>
            <pc:sldMk cId="380902020" sldId="256"/>
            <ac:spMk id="162" creationId="{4B8379F2-E3A0-44F0-BF2A-23368EA978FC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3" creationId="{D743C4E9-43C7-4027-987D-48BEC9E52349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4" creationId="{6DCBA2C7-2B38-4F5F-8E68-CBC05D0C94F7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5" creationId="{70A44036-997A-46D3-AF5D-6DE5D9ADB4F4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6" creationId="{82A53AEF-F6E3-46FC-A5D6-707A77CA60A2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7" creationId="{8A3C60A7-4449-49A3-B6AA-252E5161CA4A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8" creationId="{9E58F9A6-ADE1-4AB9-8822-2FE5D0E2391B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69" creationId="{DC382DD5-3DD7-489D-B3B0-44CAF69D4DCC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70" creationId="{B2E49A3A-16A3-40CA-BD1B-4123E8D7FAFA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71" creationId="{3A7F9685-2E87-41E8-BBD7-9AFEAB1179FA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72" creationId="{46289F9B-E3AE-4F16-BE7A-4361B26CCB29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73" creationId="{9ADBF933-10A6-46F3-8FED-8A60F3B9B4F7}"/>
          </ac:spMkLst>
        </pc:spChg>
        <pc:spChg chg="add del mod">
          <ac:chgData name="Lois Hoyer" userId="8c378a1a5b622d94" providerId="LiveId" clId="{F3D1B856-724C-4300-8492-659BEC7107D9}" dt="2021-09-09T16:36:34.234" v="827" actId="478"/>
          <ac:spMkLst>
            <pc:docMk/>
            <pc:sldMk cId="380902020" sldId="256"/>
            <ac:spMk id="173" creationId="{BB2C1AE2-3497-4083-9267-13C47FF21027}"/>
          </ac:spMkLst>
        </pc:spChg>
        <pc:spChg chg="add del mod">
          <ac:chgData name="Lois Hoyer" userId="8c378a1a5b622d94" providerId="LiveId" clId="{F3D1B856-724C-4300-8492-659BEC7107D9}" dt="2021-09-09T16:36:34.234" v="827" actId="478"/>
          <ac:spMkLst>
            <pc:docMk/>
            <pc:sldMk cId="380902020" sldId="256"/>
            <ac:spMk id="174" creationId="{52BEC32B-DCB5-4F0B-B0C3-500ACDCF9930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74" creationId="{66CA3176-0286-4A88-A58E-87C186F8126B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75" creationId="{3D5830B1-22E8-46AB-967B-A149B26C6AC4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76" creationId="{3177C37C-AEA8-49AE-B4FF-D38F755458C8}"/>
          </ac:spMkLst>
        </pc:spChg>
        <pc:spChg chg="add mod">
          <ac:chgData name="Lois Hoyer" userId="8c378a1a5b622d94" providerId="LiveId" clId="{F3D1B856-724C-4300-8492-659BEC7107D9}" dt="2021-09-16T20:12:11.770" v="2850" actId="165"/>
          <ac:spMkLst>
            <pc:docMk/>
            <pc:sldMk cId="380902020" sldId="256"/>
            <ac:spMk id="177" creationId="{5D672BC7-3DA9-49C2-B900-FEF1791AAA77}"/>
          </ac:spMkLst>
        </pc:spChg>
        <pc:spChg chg="add 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78" creationId="{5ECF92BC-1B3C-4809-BDF8-E31A98604542}"/>
          </ac:spMkLst>
        </pc:spChg>
        <pc:spChg chg="add mod topLvl">
          <ac:chgData name="Lois Hoyer" userId="8c378a1a5b622d94" providerId="LiveId" clId="{F3D1B856-724C-4300-8492-659BEC7107D9}" dt="2021-09-20T20:35:53.774" v="3053" actId="164"/>
          <ac:spMkLst>
            <pc:docMk/>
            <pc:sldMk cId="380902020" sldId="256"/>
            <ac:spMk id="179" creationId="{F8F90BDD-99FE-40EB-A58D-DE7AE378FC14}"/>
          </ac:spMkLst>
        </pc:spChg>
        <pc:spChg chg="add mod">
          <ac:chgData name="Lois Hoyer" userId="8c378a1a5b622d94" providerId="LiveId" clId="{F3D1B856-724C-4300-8492-659BEC7107D9}" dt="2021-09-09T16:46:48.053" v="994" actId="1076"/>
          <ac:spMkLst>
            <pc:docMk/>
            <pc:sldMk cId="380902020" sldId="256"/>
            <ac:spMk id="181" creationId="{CF2EF0B6-BA8D-4C0D-AD65-A12E5A7ABDF3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2" creationId="{36E4C81E-A02C-4AA0-B2A5-AE9DF43C2251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3" creationId="{83A17CE3-A296-4D34-AC14-B6FEBCB97BB7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4" creationId="{6CF14BDD-4B58-4DE8-9B63-0044CFA8E68E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5" creationId="{6C8558D6-A74C-43F9-8A03-16BA9E8F5172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6" creationId="{AD4FBC2A-7658-4C99-BD40-F75EB31E060D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7" creationId="{7FDF0280-BA8C-41CE-B23D-31D1565F4D41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8" creationId="{6A8D9DC8-AD61-4BE9-A0E5-33FEBEA43BCF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89" creationId="{75048A77-7912-466E-B3E0-3104D46C2FDA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0" creationId="{F97FAFF1-45B9-438E-9207-EAFD0E1464C7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1" creationId="{B5865C61-F71C-4FB7-9F68-FE3DB538BE6A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2" creationId="{CC8D1BBB-D9E2-4836-9C52-2DBEB9E58D9D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3" creationId="{AE4AB5C6-1B25-4E75-A15D-1936693B0679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4" creationId="{496A9A82-ED78-4410-91F9-2136B649327C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5" creationId="{6E47DE08-B576-496D-BA12-7663A061C9F5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6" creationId="{99C5B28E-878C-4B89-9B1F-BE0CE05A6926}"/>
          </ac:spMkLst>
        </pc:spChg>
        <pc:spChg chg="mod">
          <ac:chgData name="Lois Hoyer" userId="8c378a1a5b622d94" providerId="LiveId" clId="{F3D1B856-724C-4300-8492-659BEC7107D9}" dt="2021-09-16T20:12:31.869" v="2904"/>
          <ac:spMkLst>
            <pc:docMk/>
            <pc:sldMk cId="380902020" sldId="256"/>
            <ac:spMk id="197" creationId="{A9A896AB-B7D7-49FC-A3F5-13DF7645A323}"/>
          </ac:spMkLst>
        </pc:spChg>
        <pc:spChg chg="mod">
          <ac:chgData name="Lois Hoyer" userId="8c378a1a5b622d94" providerId="LiveId" clId="{F3D1B856-724C-4300-8492-659BEC7107D9}" dt="2021-09-16T20:13:07.871" v="2942"/>
          <ac:spMkLst>
            <pc:docMk/>
            <pc:sldMk cId="380902020" sldId="256"/>
            <ac:spMk id="199" creationId="{B44AD98A-A394-430C-BEEB-1BC6ABA09C3B}"/>
          </ac:spMkLst>
        </pc:spChg>
        <pc:spChg chg="mod">
          <ac:chgData name="Lois Hoyer" userId="8c378a1a5b622d94" providerId="LiveId" clId="{F3D1B856-724C-4300-8492-659BEC7107D9}" dt="2021-09-16T20:13:07.871" v="2942"/>
          <ac:spMkLst>
            <pc:docMk/>
            <pc:sldMk cId="380902020" sldId="256"/>
            <ac:spMk id="200" creationId="{9C820DA3-5D3F-459B-B214-520FDE52DA00}"/>
          </ac:spMkLst>
        </pc:spChg>
        <pc:spChg chg="mod">
          <ac:chgData name="Lois Hoyer" userId="8c378a1a5b622d94" providerId="LiveId" clId="{F3D1B856-724C-4300-8492-659BEC7107D9}" dt="2021-09-16T20:13:07.871" v="2942"/>
          <ac:spMkLst>
            <pc:docMk/>
            <pc:sldMk cId="380902020" sldId="256"/>
            <ac:spMk id="201" creationId="{297DDDD6-C03A-4144-BCDD-0A4413E00A76}"/>
          </ac:spMkLst>
        </pc:spChg>
        <pc:spChg chg="mod">
          <ac:chgData name="Lois Hoyer" userId="8c378a1a5b622d94" providerId="LiveId" clId="{F3D1B856-724C-4300-8492-659BEC7107D9}" dt="2021-09-16T20:13:07.871" v="2942"/>
          <ac:spMkLst>
            <pc:docMk/>
            <pc:sldMk cId="380902020" sldId="256"/>
            <ac:spMk id="202" creationId="{C359A11E-EAEA-4A48-B765-BDEAB01EB908}"/>
          </ac:spMkLst>
        </pc:spChg>
        <pc:spChg chg="add mod">
          <ac:chgData name="Lois Hoyer" userId="8c378a1a5b622d94" providerId="LiveId" clId="{F3D1B856-724C-4300-8492-659BEC7107D9}" dt="2021-09-16T20:13:15.297" v="2943" actId="1076"/>
          <ac:spMkLst>
            <pc:docMk/>
            <pc:sldMk cId="380902020" sldId="256"/>
            <ac:spMk id="203" creationId="{93E89B22-0875-45B9-BCDA-AAF3EEF95246}"/>
          </ac:spMkLst>
        </pc:spChg>
        <pc:grpChg chg="add mod topLvl">
          <ac:chgData name="Lois Hoyer" userId="8c378a1a5b622d94" providerId="LiveId" clId="{F3D1B856-724C-4300-8492-659BEC7107D9}" dt="2021-09-16T20:12:28.877" v="2903" actId="1035"/>
          <ac:grpSpMkLst>
            <pc:docMk/>
            <pc:sldMk cId="380902020" sldId="256"/>
            <ac:grpSpMk id="2" creationId="{FD9BFED8-B2A7-4371-8BCA-CFD40C366BB7}"/>
          </ac:grpSpMkLst>
        </pc:grpChg>
        <pc:grpChg chg="add mod topLvl">
          <ac:chgData name="Lois Hoyer" userId="8c378a1a5b622d94" providerId="LiveId" clId="{F3D1B856-724C-4300-8492-659BEC7107D9}" dt="2021-09-16T20:12:11.770" v="2850" actId="165"/>
          <ac:grpSpMkLst>
            <pc:docMk/>
            <pc:sldMk cId="380902020" sldId="256"/>
            <ac:grpSpMk id="3" creationId="{F407066C-1A68-42C3-B65F-A6210FFD18CD}"/>
          </ac:grpSpMkLst>
        </pc:grpChg>
        <pc:grpChg chg="add mod">
          <ac:chgData name="Lois Hoyer" userId="8c378a1a5b622d94" providerId="LiveId" clId="{F3D1B856-724C-4300-8492-659BEC7107D9}" dt="2021-09-20T20:35:58.119" v="3054" actId="1076"/>
          <ac:grpSpMkLst>
            <pc:docMk/>
            <pc:sldMk cId="380902020" sldId="256"/>
            <ac:grpSpMk id="30" creationId="{59974464-85BF-4075-A9F2-C451931C68F5}"/>
          </ac:grpSpMkLst>
        </pc:grpChg>
        <pc:grpChg chg="add del mod topLvl">
          <ac:chgData name="Lois Hoyer" userId="8c378a1a5b622d94" providerId="LiveId" clId="{F3D1B856-724C-4300-8492-659BEC7107D9}" dt="2021-09-16T20:12:16.388" v="2851" actId="21"/>
          <ac:grpSpMkLst>
            <pc:docMk/>
            <pc:sldMk cId="380902020" sldId="256"/>
            <ac:grpSpMk id="30" creationId="{BC8DC462-DF35-48D2-9264-442E12784A76}"/>
          </ac:grpSpMkLst>
        </pc:grpChg>
        <pc:grpChg chg="add mod topLvl">
          <ac:chgData name="Lois Hoyer" userId="8c378a1a5b622d94" providerId="LiveId" clId="{F3D1B856-724C-4300-8492-659BEC7107D9}" dt="2021-09-16T20:12:11.770" v="2850" actId="165"/>
          <ac:grpSpMkLst>
            <pc:docMk/>
            <pc:sldMk cId="380902020" sldId="256"/>
            <ac:grpSpMk id="31" creationId="{B6C10140-F0CB-43E0-A406-1384C312F7DB}"/>
          </ac:grpSpMkLst>
        </pc:grpChg>
        <pc:grpChg chg="add mod topLvl">
          <ac:chgData name="Lois Hoyer" userId="8c378a1a5b622d94" providerId="LiveId" clId="{F3D1B856-724C-4300-8492-659BEC7107D9}" dt="2021-09-16T20:13:05.013" v="2941" actId="1036"/>
          <ac:grpSpMkLst>
            <pc:docMk/>
            <pc:sldMk cId="380902020" sldId="256"/>
            <ac:grpSpMk id="32" creationId="{CA8D5CBB-B822-46AF-9413-8FFC0CAFF519}"/>
          </ac:grpSpMkLst>
        </pc:grpChg>
        <pc:grpChg chg="add del mod topLvl">
          <ac:chgData name="Lois Hoyer" userId="8c378a1a5b622d94" providerId="LiveId" clId="{F3D1B856-724C-4300-8492-659BEC7107D9}" dt="2021-09-16T20:12:57.028" v="2906" actId="21"/>
          <ac:grpSpMkLst>
            <pc:docMk/>
            <pc:sldMk cId="380902020" sldId="256"/>
            <ac:grpSpMk id="33" creationId="{20163A1C-24F3-40AF-9254-869FCE7720EB}"/>
          </ac:grpSpMkLst>
        </pc:grpChg>
        <pc:grpChg chg="add del mod topLvl">
          <ac:chgData name="Lois Hoyer" userId="8c378a1a5b622d94" providerId="LiveId" clId="{F3D1B856-724C-4300-8492-659BEC7107D9}" dt="2021-09-20T20:31:18.182" v="3001" actId="165"/>
          <ac:grpSpMkLst>
            <pc:docMk/>
            <pc:sldMk cId="380902020" sldId="256"/>
            <ac:grpSpMk id="34" creationId="{0504BF58-91FE-4C4B-B25C-CEF704620157}"/>
          </ac:grpSpMkLst>
        </pc:grpChg>
        <pc:grpChg chg="add del mod">
          <ac:chgData name="Lois Hoyer" userId="8c378a1a5b622d94" providerId="LiveId" clId="{F3D1B856-724C-4300-8492-659BEC7107D9}" dt="2021-09-20T20:30:34.259" v="2963" actId="165"/>
          <ac:grpSpMkLst>
            <pc:docMk/>
            <pc:sldMk cId="380902020" sldId="256"/>
            <ac:grpSpMk id="36" creationId="{EB41704B-246F-488A-A90E-944BC3359EA1}"/>
          </ac:grpSpMkLst>
        </pc:grpChg>
        <pc:grpChg chg="add del mod">
          <ac:chgData name="Lois Hoyer" userId="8c378a1a5b622d94" providerId="LiveId" clId="{F3D1B856-724C-4300-8492-659BEC7107D9}" dt="2021-09-16T20:12:11.770" v="2850" actId="165"/>
          <ac:grpSpMkLst>
            <pc:docMk/>
            <pc:sldMk cId="380902020" sldId="256"/>
            <ac:grpSpMk id="37" creationId="{6491E7F5-3D64-4A36-94B7-7F4E78F7C918}"/>
          </ac:grpSpMkLst>
        </pc:grpChg>
        <pc:grpChg chg="add mod">
          <ac:chgData name="Lois Hoyer" userId="8c378a1a5b622d94" providerId="LiveId" clId="{F3D1B856-724C-4300-8492-659BEC7107D9}" dt="2021-09-16T20:12:40.396" v="2905" actId="1076"/>
          <ac:grpSpMkLst>
            <pc:docMk/>
            <pc:sldMk cId="380902020" sldId="256"/>
            <ac:grpSpMk id="109" creationId="{42626F29-34EA-4617-990F-4480F523F858}"/>
          </ac:grpSpMkLst>
        </pc:grpChg>
        <pc:grpChg chg="del mod topLvl">
          <ac:chgData name="Lois Hoyer" userId="8c378a1a5b622d94" providerId="LiveId" clId="{F3D1B856-724C-4300-8492-659BEC7107D9}" dt="2021-09-09T14:14:50.616" v="125" actId="165"/>
          <ac:grpSpMkLst>
            <pc:docMk/>
            <pc:sldMk cId="380902020" sldId="256"/>
            <ac:grpSpMk id="133" creationId="{94263382-7985-4621-BE0B-1B6FA9ABC393}"/>
          </ac:grpSpMkLst>
        </pc:grpChg>
        <pc:grpChg chg="del mod topLvl">
          <ac:chgData name="Lois Hoyer" userId="8c378a1a5b622d94" providerId="LiveId" clId="{F3D1B856-724C-4300-8492-659BEC7107D9}" dt="2021-09-09T14:14:50.616" v="125" actId="165"/>
          <ac:grpSpMkLst>
            <pc:docMk/>
            <pc:sldMk cId="380902020" sldId="256"/>
            <ac:grpSpMk id="134" creationId="{9610969E-7A4C-45AB-8405-5BA146BDD319}"/>
          </ac:grpSpMkLst>
        </pc:grpChg>
        <pc:grpChg chg="del mod topLvl">
          <ac:chgData name="Lois Hoyer" userId="8c378a1a5b622d94" providerId="LiveId" clId="{F3D1B856-724C-4300-8492-659BEC7107D9}" dt="2021-09-09T14:14:50.616" v="125" actId="165"/>
          <ac:grpSpMkLst>
            <pc:docMk/>
            <pc:sldMk cId="380902020" sldId="256"/>
            <ac:grpSpMk id="136" creationId="{5FC6A1BE-C076-427E-B044-B090A59523BD}"/>
          </ac:grpSpMkLst>
        </pc:grpChg>
        <pc:grpChg chg="del">
          <ac:chgData name="Lois Hoyer" userId="8c378a1a5b622d94" providerId="LiveId" clId="{F3D1B856-724C-4300-8492-659BEC7107D9}" dt="2021-09-09T14:16:08.530" v="133" actId="165"/>
          <ac:grpSpMkLst>
            <pc:docMk/>
            <pc:sldMk cId="380902020" sldId="256"/>
            <ac:grpSpMk id="139" creationId="{8ABA59C4-8339-4A46-87AC-865B0CF151E3}"/>
          </ac:grpSpMkLst>
        </pc:grpChg>
        <pc:grpChg chg="del mod topLvl">
          <ac:chgData name="Lois Hoyer" userId="8c378a1a5b622d94" providerId="LiveId" clId="{F3D1B856-724C-4300-8492-659BEC7107D9}" dt="2021-09-09T14:14:50.616" v="125" actId="165"/>
          <ac:grpSpMkLst>
            <pc:docMk/>
            <pc:sldMk cId="380902020" sldId="256"/>
            <ac:grpSpMk id="140" creationId="{B8C4411D-C052-4789-BD09-4AD130DE7BEA}"/>
          </ac:grpSpMkLst>
        </pc:grpChg>
        <pc:grpChg chg="del mod topLvl">
          <ac:chgData name="Lois Hoyer" userId="8c378a1a5b622d94" providerId="LiveId" clId="{F3D1B856-724C-4300-8492-659BEC7107D9}" dt="2021-09-09T14:14:46.733" v="124" actId="165"/>
          <ac:grpSpMkLst>
            <pc:docMk/>
            <pc:sldMk cId="380902020" sldId="256"/>
            <ac:grpSpMk id="141" creationId="{F27D7C4B-C8F3-49DB-B9C5-B037AE720144}"/>
          </ac:grpSpMkLst>
        </pc:grpChg>
        <pc:grpChg chg="del">
          <ac:chgData name="Lois Hoyer" userId="8c378a1a5b622d94" providerId="LiveId" clId="{F3D1B856-724C-4300-8492-659BEC7107D9}" dt="2021-09-09T14:14:42.097" v="123" actId="165"/>
          <ac:grpSpMkLst>
            <pc:docMk/>
            <pc:sldMk cId="380902020" sldId="256"/>
            <ac:grpSpMk id="142" creationId="{4D86054B-E1A2-4EE6-81B6-A2A638738D6B}"/>
          </ac:grpSpMkLst>
        </pc:grpChg>
        <pc:grpChg chg="add mod">
          <ac:chgData name="Lois Hoyer" userId="8c378a1a5b622d94" providerId="LiveId" clId="{F3D1B856-724C-4300-8492-659BEC7107D9}" dt="2021-09-16T20:13:15.297" v="2943" actId="1076"/>
          <ac:grpSpMkLst>
            <pc:docMk/>
            <pc:sldMk cId="380902020" sldId="256"/>
            <ac:grpSpMk id="198" creationId="{486EEAA0-35A4-4754-A53E-3780B7BFE388}"/>
          </ac:grpSpMkLst>
        </pc:grpChg>
        <pc:graphicFrameChg chg="add mod modGraphic">
          <ac:chgData name="Lois Hoyer" userId="8c378a1a5b622d94" providerId="LiveId" clId="{F3D1B856-724C-4300-8492-659BEC7107D9}" dt="2021-09-16T20:14:34.617" v="2962" actId="20577"/>
          <ac:graphicFrameMkLst>
            <pc:docMk/>
            <pc:sldMk cId="380902020" sldId="256"/>
            <ac:graphicFrameMk id="180" creationId="{144A24EB-6719-4441-8C92-D9F1BB00B6EB}"/>
          </ac:graphicFrameMkLst>
        </pc:graphicFrameChg>
      </pc:sldChg>
      <pc:sldChg chg="addSp delSp modSp new mod">
        <pc:chgData name="Lois Hoyer" userId="8c378a1a5b622d94" providerId="LiveId" clId="{F3D1B856-724C-4300-8492-659BEC7107D9}" dt="2021-09-21T16:18:00.257" v="3828" actId="20577"/>
        <pc:sldMkLst>
          <pc:docMk/>
          <pc:sldMk cId="4087375386" sldId="257"/>
        </pc:sldMkLst>
        <pc:spChg chg="del">
          <ac:chgData name="Lois Hoyer" userId="8c378a1a5b622d94" providerId="LiveId" clId="{F3D1B856-724C-4300-8492-659BEC7107D9}" dt="2021-09-20T20:36:10.263" v="3057" actId="478"/>
          <ac:spMkLst>
            <pc:docMk/>
            <pc:sldMk cId="4087375386" sldId="257"/>
            <ac:spMk id="2" creationId="{DD52B09F-126D-4587-96A9-D5238D4BD987}"/>
          </ac:spMkLst>
        </pc:spChg>
        <pc:spChg chg="del">
          <ac:chgData name="Lois Hoyer" userId="8c378a1a5b622d94" providerId="LiveId" clId="{F3D1B856-724C-4300-8492-659BEC7107D9}" dt="2021-09-20T20:36:11.341" v="3058" actId="478"/>
          <ac:spMkLst>
            <pc:docMk/>
            <pc:sldMk cId="4087375386" sldId="257"/>
            <ac:spMk id="3" creationId="{E2B5AA65-7DE3-4CD5-9A0A-7309C873344C}"/>
          </ac:spMkLst>
        </pc:spChg>
        <pc:spChg chg="add del mod">
          <ac:chgData name="Lois Hoyer" userId="8c378a1a5b622d94" providerId="LiveId" clId="{F3D1B856-724C-4300-8492-659BEC7107D9}" dt="2021-09-20T20:51:12.880" v="3097"/>
          <ac:spMkLst>
            <pc:docMk/>
            <pc:sldMk cId="4087375386" sldId="257"/>
            <ac:spMk id="4" creationId="{AFCFCD7E-7575-4B9E-920A-E441AD2667F5}"/>
          </ac:spMkLst>
        </pc:spChg>
        <pc:spChg chg="add mod">
          <ac:chgData name="Lois Hoyer" userId="8c378a1a5b622d94" providerId="LiveId" clId="{F3D1B856-724C-4300-8492-659BEC7107D9}" dt="2021-09-21T16:18:00.257" v="3828" actId="20577"/>
          <ac:spMkLst>
            <pc:docMk/>
            <pc:sldMk cId="4087375386" sldId="257"/>
            <ac:spMk id="5" creationId="{81186539-15B9-4DDE-A189-A5C18B4FEAF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4491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44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9977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15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167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7642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8767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3413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8938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2381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02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146D1-CFD3-44CA-B4CF-80C1703819D4}" type="datetimeFigureOut">
              <a:rPr lang="en-US" smtClean="0"/>
              <a:t>10/3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B450A-E902-4F66-9E56-CE20D350A46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8132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Rectangle 3">
            <a:extLst>
              <a:ext uri="{FF2B5EF4-FFF2-40B4-BE49-F238E27FC236}">
                <a16:creationId xmlns:a16="http://schemas.microsoft.com/office/drawing/2014/main" id="{56603B88-69D2-4969-A0F8-CF996CB13C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2366" y="3425221"/>
            <a:ext cx="7701099" cy="1538883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sensus tandem repeat sequence in each protein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tAls93631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(35 aa)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PT_T_T_TW___YTTT_T__A__G_T__VI__V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 Consensus (36 aa)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_TVTTT__WS_S____T_T_T__P__T__V___E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r Consensus (36 aa)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NPT_T_T___ ______T_T_______TD______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000" b="1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lAls3274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(33 aa)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TPTSSKT_TYS_S_SRTTT_TS_GTVIVEVDV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0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pCoCm Consensus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--------------------------------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PT_T_T__WTG____T_T_T__PG_TD_V_V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lAls3274 (67 aa)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IPT_TTT_T_G_V_FTTTHTASPGG-TA__-E_DV-----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TS__TKT_T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WTG__TNT_TYTSDGTVVVE_DV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pAls Cons (80 aa)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IPTVTVT_TY_GT_TSYTTVTA_PG_TAT_IELVPEEKP_P__L__VT_TSTWTGTDTQ_T_LPYDPEVDETVTV_EL_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647DDF4-759B-481A-ABF3-7AA8F7097C11}"/>
              </a:ext>
            </a:extLst>
          </p:cNvPr>
          <p:cNvSpPr txBox="1"/>
          <p:nvPr/>
        </p:nvSpPr>
        <p:spPr>
          <a:xfrm>
            <a:off x="397889" y="843146"/>
            <a:ext cx="10689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YtAls9363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1CC8FBC-C940-4F8C-8B1D-269BFBEAFAB5}"/>
              </a:ext>
            </a:extLst>
          </p:cNvPr>
          <p:cNvSpPr txBox="1"/>
          <p:nvPr/>
        </p:nvSpPr>
        <p:spPr>
          <a:xfrm>
            <a:off x="382215" y="1756809"/>
            <a:ext cx="10689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hAls2178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F407066C-1A68-42C3-B65F-A6210FFD18CD}"/>
              </a:ext>
            </a:extLst>
          </p:cNvPr>
          <p:cNvGrpSpPr/>
          <p:nvPr/>
        </p:nvGrpSpPr>
        <p:grpSpPr>
          <a:xfrm>
            <a:off x="3434503" y="2208016"/>
            <a:ext cx="796712" cy="246221"/>
            <a:chOff x="3179917" y="2047641"/>
            <a:chExt cx="796712" cy="246221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53B7DEB-0242-4DA1-AD1A-18B89AB23B1B}"/>
                </a:ext>
              </a:extLst>
            </p:cNvPr>
            <p:cNvSpPr/>
            <p:nvPr/>
          </p:nvSpPr>
          <p:spPr>
            <a:xfrm>
              <a:off x="3179917" y="2051879"/>
              <a:ext cx="237744" cy="23774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7A22548-54DF-40F4-84DC-95AB081A9103}"/>
                </a:ext>
              </a:extLst>
            </p:cNvPr>
            <p:cNvSpPr txBox="1"/>
            <p:nvPr/>
          </p:nvSpPr>
          <p:spPr>
            <a:xfrm>
              <a:off x="3404036" y="2047641"/>
              <a:ext cx="57259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 aa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FD9BFED8-B2A7-4371-8BCA-CFD40C366BB7}"/>
              </a:ext>
            </a:extLst>
          </p:cNvPr>
          <p:cNvGrpSpPr/>
          <p:nvPr/>
        </p:nvGrpSpPr>
        <p:grpSpPr>
          <a:xfrm>
            <a:off x="596968" y="1064376"/>
            <a:ext cx="3218330" cy="228600"/>
            <a:chOff x="527413" y="1023932"/>
            <a:chExt cx="3218330" cy="228600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4C3A0DE-2C91-4535-AF7A-394814E83416}"/>
                </a:ext>
              </a:extLst>
            </p:cNvPr>
            <p:cNvSpPr/>
            <p:nvPr/>
          </p:nvSpPr>
          <p:spPr>
            <a:xfrm>
              <a:off x="564125" y="1023932"/>
              <a:ext cx="886968" cy="2286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C30B5B3-7C20-4A72-AE5A-16CC182652BF}"/>
                </a:ext>
              </a:extLst>
            </p:cNvPr>
            <p:cNvSpPr/>
            <p:nvPr/>
          </p:nvSpPr>
          <p:spPr>
            <a:xfrm>
              <a:off x="3690879" y="1023932"/>
              <a:ext cx="54864" cy="228600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7030A0"/>
                </a:solidFill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1788274D-7DAA-4CB4-B7FC-0D3AC7589C34}"/>
                </a:ext>
              </a:extLst>
            </p:cNvPr>
            <p:cNvSpPr/>
            <p:nvPr/>
          </p:nvSpPr>
          <p:spPr>
            <a:xfrm>
              <a:off x="527413" y="1023932"/>
              <a:ext cx="45720" cy="228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4"/>
                </a:solidFill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584E819-1072-44B5-AD29-2BC2E3E3F614}"/>
                </a:ext>
              </a:extLst>
            </p:cNvPr>
            <p:cNvSpPr/>
            <p:nvPr/>
          </p:nvSpPr>
          <p:spPr>
            <a:xfrm>
              <a:off x="2325467" y="1023932"/>
              <a:ext cx="82296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0EA8121A-2563-4FAB-9306-905C2FBAE103}"/>
                </a:ext>
              </a:extLst>
            </p:cNvPr>
            <p:cNvSpPr/>
            <p:nvPr/>
          </p:nvSpPr>
          <p:spPr>
            <a:xfrm>
              <a:off x="3188037" y="1023932"/>
              <a:ext cx="502920" cy="228600"/>
            </a:xfrm>
            <a:prstGeom prst="rect">
              <a:avLst/>
            </a:prstGeom>
            <a:solidFill>
              <a:srgbClr val="0066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671991C7-55BE-4B38-8499-4BC83CF330C2}"/>
                </a:ext>
              </a:extLst>
            </p:cNvPr>
            <p:cNvSpPr/>
            <p:nvPr/>
          </p:nvSpPr>
          <p:spPr>
            <a:xfrm>
              <a:off x="1456365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57EC84E6-98DA-45C6-8227-41F49A2CD02A}"/>
                </a:ext>
              </a:extLst>
            </p:cNvPr>
            <p:cNvSpPr/>
            <p:nvPr/>
          </p:nvSpPr>
          <p:spPr>
            <a:xfrm>
              <a:off x="1536745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FD0AC64-0912-458A-B668-81CE91F1BF25}"/>
                </a:ext>
              </a:extLst>
            </p:cNvPr>
            <p:cNvSpPr/>
            <p:nvPr/>
          </p:nvSpPr>
          <p:spPr>
            <a:xfrm>
              <a:off x="1621427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4076AB1-52D6-41EC-ACB9-9146159F994F}"/>
                </a:ext>
              </a:extLst>
            </p:cNvPr>
            <p:cNvSpPr/>
            <p:nvPr/>
          </p:nvSpPr>
          <p:spPr>
            <a:xfrm>
              <a:off x="1699285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6159DAA-3378-4CFD-B48B-4085884F2CA5}"/>
                </a:ext>
              </a:extLst>
            </p:cNvPr>
            <p:cNvSpPr/>
            <p:nvPr/>
          </p:nvSpPr>
          <p:spPr>
            <a:xfrm>
              <a:off x="1783967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8B6CEA89-DEA2-4B7D-852D-630D11CF0599}"/>
                </a:ext>
              </a:extLst>
            </p:cNvPr>
            <p:cNvSpPr/>
            <p:nvPr/>
          </p:nvSpPr>
          <p:spPr>
            <a:xfrm>
              <a:off x="1868649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2B03AF00-5801-4B5C-9D1A-9B510178875B}"/>
                </a:ext>
              </a:extLst>
            </p:cNvPr>
            <p:cNvSpPr/>
            <p:nvPr/>
          </p:nvSpPr>
          <p:spPr>
            <a:xfrm>
              <a:off x="1946507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8ED943C0-4F00-4CE1-8CE0-E8D84A631131}"/>
                </a:ext>
              </a:extLst>
            </p:cNvPr>
            <p:cNvSpPr/>
            <p:nvPr/>
          </p:nvSpPr>
          <p:spPr>
            <a:xfrm>
              <a:off x="2018489" y="1023932"/>
              <a:ext cx="73152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B6234098-4491-4151-8F6D-6566CCD8E1EF}"/>
                </a:ext>
              </a:extLst>
            </p:cNvPr>
            <p:cNvSpPr/>
            <p:nvPr/>
          </p:nvSpPr>
          <p:spPr>
            <a:xfrm>
              <a:off x="2090471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F4C54DE-4B3F-4AC3-AB9C-C14045395109}"/>
                </a:ext>
              </a:extLst>
            </p:cNvPr>
            <p:cNvSpPr/>
            <p:nvPr/>
          </p:nvSpPr>
          <p:spPr>
            <a:xfrm>
              <a:off x="2168803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8AB1D928-8435-4347-AA6F-5EAD0778F64F}"/>
                </a:ext>
              </a:extLst>
            </p:cNvPr>
            <p:cNvSpPr/>
            <p:nvPr/>
          </p:nvSpPr>
          <p:spPr>
            <a:xfrm>
              <a:off x="2253485" y="1023932"/>
              <a:ext cx="73152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AE88B02D-1F58-4D12-9B2F-104DE09B04E1}"/>
                </a:ext>
              </a:extLst>
            </p:cNvPr>
            <p:cNvSpPr/>
            <p:nvPr/>
          </p:nvSpPr>
          <p:spPr>
            <a:xfrm>
              <a:off x="2490997" y="1023932"/>
              <a:ext cx="109728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C365E4A-95A8-458B-A2ED-9C4B6A172947}"/>
                </a:ext>
              </a:extLst>
            </p:cNvPr>
            <p:cNvSpPr/>
            <p:nvPr/>
          </p:nvSpPr>
          <p:spPr>
            <a:xfrm>
              <a:off x="2604151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674B89E5-5CA4-44B1-925B-516FC21D429F}"/>
                </a:ext>
              </a:extLst>
            </p:cNvPr>
            <p:cNvSpPr/>
            <p:nvPr/>
          </p:nvSpPr>
          <p:spPr>
            <a:xfrm>
              <a:off x="2688359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DCD11C46-4AD5-4580-B4DA-978CCC459D5A}"/>
                </a:ext>
              </a:extLst>
            </p:cNvPr>
            <p:cNvSpPr/>
            <p:nvPr/>
          </p:nvSpPr>
          <p:spPr>
            <a:xfrm>
              <a:off x="2766691" y="1023932"/>
              <a:ext cx="91440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02795E41-B6F1-4E3F-B02D-BA18EC34DE78}"/>
                </a:ext>
              </a:extLst>
            </p:cNvPr>
            <p:cNvSpPr/>
            <p:nvPr/>
          </p:nvSpPr>
          <p:spPr>
            <a:xfrm>
              <a:off x="2857723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35E50ACA-C8DC-408A-9A4F-E42555A36035}"/>
                </a:ext>
              </a:extLst>
            </p:cNvPr>
            <p:cNvSpPr/>
            <p:nvPr/>
          </p:nvSpPr>
          <p:spPr>
            <a:xfrm>
              <a:off x="2941931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F0C53207-1C06-4CAF-9368-D198DD1B2D26}"/>
                </a:ext>
              </a:extLst>
            </p:cNvPr>
            <p:cNvSpPr/>
            <p:nvPr/>
          </p:nvSpPr>
          <p:spPr>
            <a:xfrm>
              <a:off x="2406593" y="1023932"/>
              <a:ext cx="82296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12D30921-7CB7-42A4-9256-404970B5B152}"/>
                </a:ext>
              </a:extLst>
            </p:cNvPr>
            <p:cNvSpPr/>
            <p:nvPr/>
          </p:nvSpPr>
          <p:spPr>
            <a:xfrm>
              <a:off x="3013913" y="1023932"/>
              <a:ext cx="91440" cy="22860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6">
                    <a:lumMod val="50000"/>
                  </a:schemeClr>
                </a:solidFill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E1F38D94-51CF-4B8F-82CF-B18F4A0FEA9A}"/>
                </a:ext>
              </a:extLst>
            </p:cNvPr>
            <p:cNvSpPr/>
            <p:nvPr/>
          </p:nvSpPr>
          <p:spPr>
            <a:xfrm>
              <a:off x="3107265" y="1023932"/>
              <a:ext cx="82296" cy="2286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B6C10140-F0CB-43E0-A406-1384C312F7DB}"/>
              </a:ext>
            </a:extLst>
          </p:cNvPr>
          <p:cNvGrpSpPr/>
          <p:nvPr/>
        </p:nvGrpSpPr>
        <p:grpSpPr>
          <a:xfrm>
            <a:off x="596968" y="1960031"/>
            <a:ext cx="1787540" cy="230808"/>
            <a:chOff x="528894" y="2095136"/>
            <a:chExt cx="1787540" cy="230808"/>
          </a:xfrm>
        </p:grpSpPr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824E47CC-CB90-4275-94FC-18A57D89BF2E}"/>
                </a:ext>
              </a:extLst>
            </p:cNvPr>
            <p:cNvSpPr/>
            <p:nvPr/>
          </p:nvSpPr>
          <p:spPr>
            <a:xfrm>
              <a:off x="528894" y="2097344"/>
              <a:ext cx="45720" cy="228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4"/>
                </a:solidFill>
              </a:endParaRPr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57130DC9-C168-406B-A671-4A916B5EE5CF}"/>
                </a:ext>
              </a:extLst>
            </p:cNvPr>
            <p:cNvSpPr/>
            <p:nvPr/>
          </p:nvSpPr>
          <p:spPr>
            <a:xfrm>
              <a:off x="574055" y="2095681"/>
              <a:ext cx="740664" cy="2286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D6F8BF60-A1E7-43DB-B7B9-ABA883130456}"/>
                </a:ext>
              </a:extLst>
            </p:cNvPr>
            <p:cNvSpPr/>
            <p:nvPr/>
          </p:nvSpPr>
          <p:spPr>
            <a:xfrm>
              <a:off x="1312415" y="2095136"/>
              <a:ext cx="960120" cy="228600"/>
            </a:xfrm>
            <a:prstGeom prst="rect">
              <a:avLst/>
            </a:prstGeom>
            <a:solidFill>
              <a:srgbClr val="3333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87AB9E63-6A40-4ED1-B3AC-0A4639DEBB54}"/>
                </a:ext>
              </a:extLst>
            </p:cNvPr>
            <p:cNvSpPr/>
            <p:nvPr/>
          </p:nvSpPr>
          <p:spPr>
            <a:xfrm>
              <a:off x="2270714" y="2095136"/>
              <a:ext cx="45720" cy="228600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7030A0"/>
                </a:solidFill>
              </a:endParaRP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CA8D5CBB-B822-46AF-9413-8FFC0CAFF519}"/>
              </a:ext>
            </a:extLst>
          </p:cNvPr>
          <p:cNvGrpSpPr/>
          <p:nvPr/>
        </p:nvGrpSpPr>
        <p:grpSpPr>
          <a:xfrm>
            <a:off x="596968" y="2850493"/>
            <a:ext cx="1536334" cy="230808"/>
            <a:chOff x="528894" y="2587680"/>
            <a:chExt cx="1536334" cy="230808"/>
          </a:xfrm>
        </p:grpSpPr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3DA3AD4D-E025-48DF-A719-8ABC9F27E914}"/>
                </a:ext>
              </a:extLst>
            </p:cNvPr>
            <p:cNvSpPr/>
            <p:nvPr/>
          </p:nvSpPr>
          <p:spPr>
            <a:xfrm>
              <a:off x="528894" y="2589888"/>
              <a:ext cx="45720" cy="228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4"/>
                </a:solidFill>
              </a:endParaRPr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F0ECB918-04C8-4702-8F17-F5DC46B29AF7}"/>
                </a:ext>
              </a:extLst>
            </p:cNvPr>
            <p:cNvSpPr/>
            <p:nvPr/>
          </p:nvSpPr>
          <p:spPr>
            <a:xfrm>
              <a:off x="572959" y="2589888"/>
              <a:ext cx="722376" cy="2286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F8C084B1-4A95-4479-9509-E012CDD039DB}"/>
                </a:ext>
              </a:extLst>
            </p:cNvPr>
            <p:cNvSpPr/>
            <p:nvPr/>
          </p:nvSpPr>
          <p:spPr>
            <a:xfrm>
              <a:off x="1293365" y="2587680"/>
              <a:ext cx="722376" cy="228600"/>
            </a:xfrm>
            <a:prstGeom prst="rect">
              <a:avLst/>
            </a:prstGeom>
            <a:solidFill>
              <a:srgbClr val="3333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581D53A7-8D5B-4BCB-A892-AD6878A00F0B}"/>
                </a:ext>
              </a:extLst>
            </p:cNvPr>
            <p:cNvSpPr/>
            <p:nvPr/>
          </p:nvSpPr>
          <p:spPr>
            <a:xfrm>
              <a:off x="2010364" y="2587680"/>
              <a:ext cx="54864" cy="228600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7030A0"/>
                </a:solidFill>
              </a:endParaRPr>
            </a:p>
          </p:txBody>
        </p:sp>
      </p:grpSp>
      <p:sp>
        <p:nvSpPr>
          <p:cNvPr id="150" name="TextBox 149">
            <a:extLst>
              <a:ext uri="{FF2B5EF4-FFF2-40B4-BE49-F238E27FC236}">
                <a16:creationId xmlns:a16="http://schemas.microsoft.com/office/drawing/2014/main" id="{642E4670-D655-4667-8EF3-2CA0B091D272}"/>
              </a:ext>
            </a:extLst>
          </p:cNvPr>
          <p:cNvSpPr txBox="1"/>
          <p:nvPr/>
        </p:nvSpPr>
        <p:spPr>
          <a:xfrm>
            <a:off x="275394" y="2647232"/>
            <a:ext cx="10689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cSag1	</a:t>
            </a:r>
          </a:p>
        </p:txBody>
      </p:sp>
      <p:graphicFrame>
        <p:nvGraphicFramePr>
          <p:cNvPr id="180" name="Table 179">
            <a:extLst>
              <a:ext uri="{FF2B5EF4-FFF2-40B4-BE49-F238E27FC236}">
                <a16:creationId xmlns:a16="http://schemas.microsoft.com/office/drawing/2014/main" id="{144A24EB-6719-4441-8C92-D9F1BB00B6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7599464"/>
              </p:ext>
            </p:extLst>
          </p:nvPr>
        </p:nvGraphicFramePr>
        <p:xfrm>
          <a:off x="1770154" y="5336543"/>
          <a:ext cx="5592488" cy="117348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818198">
                  <a:extLst>
                    <a:ext uri="{9D8B030D-6E8A-4147-A177-3AD203B41FA5}">
                      <a16:colId xmlns:a16="http://schemas.microsoft.com/office/drawing/2014/main" val="2131190332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509173655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1583704248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936704474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959378178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4285163691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445785930"/>
                    </a:ext>
                  </a:extLst>
                </a:gridCol>
              </a:tblGrid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Als327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tAls9363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hAls217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GL4125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Sag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828127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Als327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936531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tAls9363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341924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hAls217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225445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GL4125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4403074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Sag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4973000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8811084"/>
                  </a:ext>
                </a:extLst>
              </a:tr>
            </a:tbl>
          </a:graphicData>
        </a:graphic>
      </p:graphicFrame>
      <p:sp>
        <p:nvSpPr>
          <p:cNvPr id="181" name="TextBox 180">
            <a:extLst>
              <a:ext uri="{FF2B5EF4-FFF2-40B4-BE49-F238E27FC236}">
                <a16:creationId xmlns:a16="http://schemas.microsoft.com/office/drawing/2014/main" id="{CF2EF0B6-BA8D-4C0D-AD65-A12E5A7ABDF3}"/>
              </a:ext>
            </a:extLst>
          </p:cNvPr>
          <p:cNvSpPr txBox="1"/>
          <p:nvPr/>
        </p:nvSpPr>
        <p:spPr>
          <a:xfrm>
            <a:off x="1943725" y="5096458"/>
            <a:ext cx="52453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ercent identity values for comparisons between NT-Als sequences in each protein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2E800E5-18F0-4F7A-B242-6362919FEE90}"/>
              </a:ext>
            </a:extLst>
          </p:cNvPr>
          <p:cNvSpPr txBox="1"/>
          <p:nvPr/>
        </p:nvSpPr>
        <p:spPr>
          <a:xfrm>
            <a:off x="359722" y="1302453"/>
            <a:ext cx="10689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Als3274</a:t>
            </a:r>
          </a:p>
        </p:txBody>
      </p: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42626F29-34EA-4617-990F-4480F523F858}"/>
              </a:ext>
            </a:extLst>
          </p:cNvPr>
          <p:cNvGrpSpPr/>
          <p:nvPr/>
        </p:nvGrpSpPr>
        <p:grpSpPr>
          <a:xfrm>
            <a:off x="596968" y="1509947"/>
            <a:ext cx="5537539" cy="228600"/>
            <a:chOff x="527413" y="1496498"/>
            <a:chExt cx="5537539" cy="228600"/>
          </a:xfrm>
        </p:grpSpPr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004F98B7-8556-4B59-8FE0-C4FF329C8079}"/>
                </a:ext>
              </a:extLst>
            </p:cNvPr>
            <p:cNvSpPr/>
            <p:nvPr/>
          </p:nvSpPr>
          <p:spPr>
            <a:xfrm>
              <a:off x="1425207" y="1496787"/>
              <a:ext cx="82296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373ABBC9-63F7-46D4-8610-DC337290A6AA}"/>
                </a:ext>
              </a:extLst>
            </p:cNvPr>
            <p:cNvSpPr/>
            <p:nvPr/>
          </p:nvSpPr>
          <p:spPr>
            <a:xfrm>
              <a:off x="1501994" y="1496787"/>
              <a:ext cx="54864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3" name="Rectangle 132">
              <a:extLst>
                <a:ext uri="{FF2B5EF4-FFF2-40B4-BE49-F238E27FC236}">
                  <a16:creationId xmlns:a16="http://schemas.microsoft.com/office/drawing/2014/main" id="{14FB80F4-E151-4512-A8CA-1AF79A652019}"/>
                </a:ext>
              </a:extLst>
            </p:cNvPr>
            <p:cNvSpPr/>
            <p:nvPr/>
          </p:nvSpPr>
          <p:spPr>
            <a:xfrm>
              <a:off x="1557699" y="1496787"/>
              <a:ext cx="82296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4AC519ED-769A-4C48-91AC-327A65ADCF26}"/>
                </a:ext>
              </a:extLst>
            </p:cNvPr>
            <p:cNvSpPr/>
            <p:nvPr/>
          </p:nvSpPr>
          <p:spPr>
            <a:xfrm>
              <a:off x="1640836" y="1496787"/>
              <a:ext cx="82296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13147A75-5752-497D-8230-D359D6D5F709}"/>
                </a:ext>
              </a:extLst>
            </p:cNvPr>
            <p:cNvSpPr/>
            <p:nvPr/>
          </p:nvSpPr>
          <p:spPr>
            <a:xfrm>
              <a:off x="1723973" y="1496787"/>
              <a:ext cx="82296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60611EBA-8ED4-436F-BA86-886265C1B901}"/>
                </a:ext>
              </a:extLst>
            </p:cNvPr>
            <p:cNvSpPr/>
            <p:nvPr/>
          </p:nvSpPr>
          <p:spPr>
            <a:xfrm>
              <a:off x="1800760" y="1496787"/>
              <a:ext cx="82296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978F2004-693F-48DF-95BE-F3A30D21CE77}"/>
                </a:ext>
              </a:extLst>
            </p:cNvPr>
            <p:cNvSpPr/>
            <p:nvPr/>
          </p:nvSpPr>
          <p:spPr>
            <a:xfrm>
              <a:off x="1883897" y="1496787"/>
              <a:ext cx="82296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6B2C83B1-52E2-454F-9CB0-46A76FFD37FA}"/>
                </a:ext>
              </a:extLst>
            </p:cNvPr>
            <p:cNvSpPr/>
            <p:nvPr/>
          </p:nvSpPr>
          <p:spPr>
            <a:xfrm>
              <a:off x="1967034" y="1496787"/>
              <a:ext cx="64008" cy="228022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D2D7F561-8BD9-44C6-ADCB-D5B9267A1D44}"/>
                </a:ext>
              </a:extLst>
            </p:cNvPr>
            <p:cNvSpPr/>
            <p:nvPr/>
          </p:nvSpPr>
          <p:spPr>
            <a:xfrm>
              <a:off x="5469750" y="1496787"/>
              <a:ext cx="539496" cy="228022"/>
            </a:xfrm>
            <a:prstGeom prst="rect">
              <a:avLst/>
            </a:prstGeom>
            <a:solidFill>
              <a:srgbClr val="33669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FEBBC7D6-FC15-4FD5-BE2A-CC7CF810B03B}"/>
                </a:ext>
              </a:extLst>
            </p:cNvPr>
            <p:cNvSpPr/>
            <p:nvPr/>
          </p:nvSpPr>
          <p:spPr>
            <a:xfrm>
              <a:off x="6010088" y="1496787"/>
              <a:ext cx="54864" cy="228022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dirty="0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CB964D13-9C3C-48D7-B751-AFB0DC26D5DE}"/>
                </a:ext>
              </a:extLst>
            </p:cNvPr>
            <p:cNvSpPr/>
            <p:nvPr/>
          </p:nvSpPr>
          <p:spPr>
            <a:xfrm>
              <a:off x="527413" y="1496498"/>
              <a:ext cx="45720" cy="228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4"/>
                </a:solidFill>
              </a:endParaRPr>
            </a:p>
          </p:txBody>
        </p: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id="{C8A5A13C-4D25-433E-8B33-CEEF33EC1A38}"/>
                </a:ext>
              </a:extLst>
            </p:cNvPr>
            <p:cNvSpPr/>
            <p:nvPr/>
          </p:nvSpPr>
          <p:spPr>
            <a:xfrm>
              <a:off x="573974" y="1496498"/>
              <a:ext cx="850392" cy="2286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1B90E1D6-DDE3-4DF7-B996-EEA5B7A5A2FB}"/>
                </a:ext>
              </a:extLst>
            </p:cNvPr>
            <p:cNvSpPr/>
            <p:nvPr/>
          </p:nvSpPr>
          <p:spPr>
            <a:xfrm>
              <a:off x="2031883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9ADBF933-10A6-46F3-8FED-8A60F3B9B4F7}"/>
                </a:ext>
              </a:extLst>
            </p:cNvPr>
            <p:cNvSpPr/>
            <p:nvPr/>
          </p:nvSpPr>
          <p:spPr>
            <a:xfrm>
              <a:off x="2181822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66CA3176-0286-4A88-A58E-87C186F8126B}"/>
                </a:ext>
              </a:extLst>
            </p:cNvPr>
            <p:cNvSpPr/>
            <p:nvPr/>
          </p:nvSpPr>
          <p:spPr>
            <a:xfrm>
              <a:off x="2338111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36E4C81E-A02C-4AA0-B2A5-AE9DF43C2251}"/>
                </a:ext>
              </a:extLst>
            </p:cNvPr>
            <p:cNvSpPr/>
            <p:nvPr/>
          </p:nvSpPr>
          <p:spPr>
            <a:xfrm>
              <a:off x="2494400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83A17CE3-A296-4D34-AC14-B6FEBCB97BB7}"/>
                </a:ext>
              </a:extLst>
            </p:cNvPr>
            <p:cNvSpPr/>
            <p:nvPr/>
          </p:nvSpPr>
          <p:spPr>
            <a:xfrm>
              <a:off x="2650689" y="1496498"/>
              <a:ext cx="237744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6CF14BDD-4B58-4DE8-9B63-0044CFA8E68E}"/>
                </a:ext>
              </a:extLst>
            </p:cNvPr>
            <p:cNvSpPr/>
            <p:nvPr/>
          </p:nvSpPr>
          <p:spPr>
            <a:xfrm>
              <a:off x="2889274" y="1496498"/>
              <a:ext cx="237744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6C8558D6-A74C-43F9-8A03-16BA9E8F5172}"/>
                </a:ext>
              </a:extLst>
            </p:cNvPr>
            <p:cNvSpPr/>
            <p:nvPr/>
          </p:nvSpPr>
          <p:spPr>
            <a:xfrm>
              <a:off x="3121509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AD4FBC2A-7658-4C99-BD40-F75EB31E060D}"/>
                </a:ext>
              </a:extLst>
            </p:cNvPr>
            <p:cNvSpPr/>
            <p:nvPr/>
          </p:nvSpPr>
          <p:spPr>
            <a:xfrm>
              <a:off x="3277798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7FDF0280-BA8C-41CE-B23D-31D1565F4D41}"/>
                </a:ext>
              </a:extLst>
            </p:cNvPr>
            <p:cNvSpPr/>
            <p:nvPr/>
          </p:nvSpPr>
          <p:spPr>
            <a:xfrm>
              <a:off x="3434087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6A8D9DC8-AD61-4BE9-A0E5-33FEBEA43BCF}"/>
                </a:ext>
              </a:extLst>
            </p:cNvPr>
            <p:cNvSpPr/>
            <p:nvPr/>
          </p:nvSpPr>
          <p:spPr>
            <a:xfrm>
              <a:off x="3590376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9" name="Rectangle 188">
              <a:extLst>
                <a:ext uri="{FF2B5EF4-FFF2-40B4-BE49-F238E27FC236}">
                  <a16:creationId xmlns:a16="http://schemas.microsoft.com/office/drawing/2014/main" id="{75048A77-7912-466E-B3E0-3104D46C2FDA}"/>
                </a:ext>
              </a:extLst>
            </p:cNvPr>
            <p:cNvSpPr/>
            <p:nvPr/>
          </p:nvSpPr>
          <p:spPr>
            <a:xfrm>
              <a:off x="3746665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F97FAFF1-45B9-438E-9207-EAFD0E1464C7}"/>
                </a:ext>
              </a:extLst>
            </p:cNvPr>
            <p:cNvSpPr/>
            <p:nvPr/>
          </p:nvSpPr>
          <p:spPr>
            <a:xfrm>
              <a:off x="3902954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1" name="Rectangle 190">
              <a:extLst>
                <a:ext uri="{FF2B5EF4-FFF2-40B4-BE49-F238E27FC236}">
                  <a16:creationId xmlns:a16="http://schemas.microsoft.com/office/drawing/2014/main" id="{B5865C61-F71C-4FB7-9F68-FE3DB538BE6A}"/>
                </a:ext>
              </a:extLst>
            </p:cNvPr>
            <p:cNvSpPr/>
            <p:nvPr/>
          </p:nvSpPr>
          <p:spPr>
            <a:xfrm>
              <a:off x="4297828" y="1496498"/>
              <a:ext cx="237744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2" name="Rectangle 191">
              <a:extLst>
                <a:ext uri="{FF2B5EF4-FFF2-40B4-BE49-F238E27FC236}">
                  <a16:creationId xmlns:a16="http://schemas.microsoft.com/office/drawing/2014/main" id="{CC8D1BBB-D9E2-4836-9C52-2DBEB9E58D9D}"/>
                </a:ext>
              </a:extLst>
            </p:cNvPr>
            <p:cNvSpPr/>
            <p:nvPr/>
          </p:nvSpPr>
          <p:spPr>
            <a:xfrm>
              <a:off x="4059243" y="1496498"/>
              <a:ext cx="237744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AE4AB5C6-1B25-4E75-A15D-1936693B0679}"/>
                </a:ext>
              </a:extLst>
            </p:cNvPr>
            <p:cNvSpPr/>
            <p:nvPr/>
          </p:nvSpPr>
          <p:spPr>
            <a:xfrm>
              <a:off x="4536413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496A9A82-ED78-4410-91F9-2136B649327C}"/>
                </a:ext>
              </a:extLst>
            </p:cNvPr>
            <p:cNvSpPr/>
            <p:nvPr/>
          </p:nvSpPr>
          <p:spPr>
            <a:xfrm>
              <a:off x="4686352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id="{6E47DE08-B576-496D-BA12-7663A061C9F5}"/>
                </a:ext>
              </a:extLst>
            </p:cNvPr>
            <p:cNvSpPr/>
            <p:nvPr/>
          </p:nvSpPr>
          <p:spPr>
            <a:xfrm>
              <a:off x="4836291" y="1496498"/>
              <a:ext cx="237744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6" name="Rectangle 195">
              <a:extLst>
                <a:ext uri="{FF2B5EF4-FFF2-40B4-BE49-F238E27FC236}">
                  <a16:creationId xmlns:a16="http://schemas.microsoft.com/office/drawing/2014/main" id="{99C5B28E-878C-4B89-9B1F-BE0CE05A6926}"/>
                </a:ext>
              </a:extLst>
            </p:cNvPr>
            <p:cNvSpPr/>
            <p:nvPr/>
          </p:nvSpPr>
          <p:spPr>
            <a:xfrm>
              <a:off x="5074876" y="1496498"/>
              <a:ext cx="237744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7" name="Rectangle 196">
              <a:extLst>
                <a:ext uri="{FF2B5EF4-FFF2-40B4-BE49-F238E27FC236}">
                  <a16:creationId xmlns:a16="http://schemas.microsoft.com/office/drawing/2014/main" id="{A9A896AB-B7D7-49FC-A3F5-13DF7645A323}"/>
                </a:ext>
              </a:extLst>
            </p:cNvPr>
            <p:cNvSpPr/>
            <p:nvPr/>
          </p:nvSpPr>
          <p:spPr>
            <a:xfrm>
              <a:off x="5313461" y="1496498"/>
              <a:ext cx="155448" cy="2286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</p:grpSp>
      <p:grpSp>
        <p:nvGrpSpPr>
          <p:cNvPr id="198" name="Group 197">
            <a:extLst>
              <a:ext uri="{FF2B5EF4-FFF2-40B4-BE49-F238E27FC236}">
                <a16:creationId xmlns:a16="http://schemas.microsoft.com/office/drawing/2014/main" id="{486EEAA0-35A4-4754-A53E-3780B7BFE388}"/>
              </a:ext>
            </a:extLst>
          </p:cNvPr>
          <p:cNvGrpSpPr/>
          <p:nvPr/>
        </p:nvGrpSpPr>
        <p:grpSpPr>
          <a:xfrm>
            <a:off x="588305" y="2409807"/>
            <a:ext cx="1811232" cy="230808"/>
            <a:chOff x="563895" y="3060991"/>
            <a:chExt cx="1811232" cy="230808"/>
          </a:xfrm>
        </p:grpSpPr>
        <p:sp>
          <p:nvSpPr>
            <p:cNvPr id="199" name="Rectangle 198">
              <a:extLst>
                <a:ext uri="{FF2B5EF4-FFF2-40B4-BE49-F238E27FC236}">
                  <a16:creationId xmlns:a16="http://schemas.microsoft.com/office/drawing/2014/main" id="{B44AD98A-A394-430C-BEEB-1BC6ABA09C3B}"/>
                </a:ext>
              </a:extLst>
            </p:cNvPr>
            <p:cNvSpPr/>
            <p:nvPr/>
          </p:nvSpPr>
          <p:spPr>
            <a:xfrm>
              <a:off x="563895" y="3063199"/>
              <a:ext cx="45720" cy="2286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accent4"/>
                </a:solidFill>
              </a:endParaRPr>
            </a:p>
          </p:txBody>
        </p:sp>
        <p:sp>
          <p:nvSpPr>
            <p:cNvPr id="200" name="Rectangle 199">
              <a:extLst>
                <a:ext uri="{FF2B5EF4-FFF2-40B4-BE49-F238E27FC236}">
                  <a16:creationId xmlns:a16="http://schemas.microsoft.com/office/drawing/2014/main" id="{9C820DA3-5D3F-459B-B214-520FDE52DA00}"/>
                </a:ext>
              </a:extLst>
            </p:cNvPr>
            <p:cNvSpPr/>
            <p:nvPr/>
          </p:nvSpPr>
          <p:spPr>
            <a:xfrm>
              <a:off x="607960" y="3063199"/>
              <a:ext cx="722376" cy="2286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1" name="Rectangle 200">
              <a:extLst>
                <a:ext uri="{FF2B5EF4-FFF2-40B4-BE49-F238E27FC236}">
                  <a16:creationId xmlns:a16="http://schemas.microsoft.com/office/drawing/2014/main" id="{297DDDD6-C03A-4144-BCDD-0A4413E00A76}"/>
                </a:ext>
              </a:extLst>
            </p:cNvPr>
            <p:cNvSpPr/>
            <p:nvPr/>
          </p:nvSpPr>
          <p:spPr>
            <a:xfrm>
              <a:off x="1328366" y="3060991"/>
              <a:ext cx="987552" cy="228600"/>
            </a:xfrm>
            <a:prstGeom prst="rect">
              <a:avLst/>
            </a:prstGeom>
            <a:solidFill>
              <a:srgbClr val="3333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2" name="Rectangle 201">
              <a:extLst>
                <a:ext uri="{FF2B5EF4-FFF2-40B4-BE49-F238E27FC236}">
                  <a16:creationId xmlns:a16="http://schemas.microsoft.com/office/drawing/2014/main" id="{C359A11E-EAEA-4A48-B765-BDEAB01EB908}"/>
                </a:ext>
              </a:extLst>
            </p:cNvPr>
            <p:cNvSpPr/>
            <p:nvPr/>
          </p:nvSpPr>
          <p:spPr>
            <a:xfrm>
              <a:off x="2320263" y="3060991"/>
              <a:ext cx="54864" cy="228600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7030A0"/>
                </a:solidFill>
              </a:endParaRPr>
            </a:p>
          </p:txBody>
        </p:sp>
      </p:grpSp>
      <p:sp>
        <p:nvSpPr>
          <p:cNvPr id="203" name="TextBox 202">
            <a:extLst>
              <a:ext uri="{FF2B5EF4-FFF2-40B4-BE49-F238E27FC236}">
                <a16:creationId xmlns:a16="http://schemas.microsoft.com/office/drawing/2014/main" id="{93E89B22-0875-45B9-BCDA-AAF3EEF95246}"/>
              </a:ext>
            </a:extLst>
          </p:cNvPr>
          <p:cNvSpPr txBox="1"/>
          <p:nvPr/>
        </p:nvSpPr>
        <p:spPr>
          <a:xfrm>
            <a:off x="457664" y="2211282"/>
            <a:ext cx="1147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AGL0G04125	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59974464-85BF-4075-A9F2-C451931C68F5}"/>
              </a:ext>
            </a:extLst>
          </p:cNvPr>
          <p:cNvGrpSpPr/>
          <p:nvPr/>
        </p:nvGrpSpPr>
        <p:grpSpPr>
          <a:xfrm>
            <a:off x="5022376" y="1960751"/>
            <a:ext cx="2967158" cy="1136020"/>
            <a:chOff x="4771563" y="2168505"/>
            <a:chExt cx="2967158" cy="1136020"/>
          </a:xfrm>
        </p:grpSpPr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7E0F1560-C29E-4073-9F75-68ACF0D10CE8}"/>
                </a:ext>
              </a:extLst>
            </p:cNvPr>
            <p:cNvSpPr/>
            <p:nvPr/>
          </p:nvSpPr>
          <p:spPr>
            <a:xfrm>
              <a:off x="4949202" y="2328101"/>
              <a:ext cx="152400" cy="152400"/>
            </a:xfrm>
            <a:prstGeom prst="rect">
              <a:avLst/>
            </a:prstGeom>
            <a:solidFill>
              <a:srgbClr val="FFC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A4120B7B-1062-48A4-92B0-A6B7DE0A752D}"/>
                </a:ext>
              </a:extLst>
            </p:cNvPr>
            <p:cNvSpPr/>
            <p:nvPr/>
          </p:nvSpPr>
          <p:spPr>
            <a:xfrm>
              <a:off x="4949202" y="2552868"/>
              <a:ext cx="152400" cy="1524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45FED51F-C253-4509-BE45-D5C169B53156}"/>
                </a:ext>
              </a:extLst>
            </p:cNvPr>
            <p:cNvSpPr/>
            <p:nvPr/>
          </p:nvSpPr>
          <p:spPr>
            <a:xfrm>
              <a:off x="6576405" y="2656467"/>
              <a:ext cx="152400" cy="152400"/>
            </a:xfrm>
            <a:prstGeom prst="rect">
              <a:avLst/>
            </a:prstGeom>
            <a:solidFill>
              <a:srgbClr val="0066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BD5B035F-0678-4F40-91E5-D65C0342FA01}"/>
                </a:ext>
              </a:extLst>
            </p:cNvPr>
            <p:cNvSpPr/>
            <p:nvPr/>
          </p:nvSpPr>
          <p:spPr>
            <a:xfrm>
              <a:off x="6576405" y="2425490"/>
              <a:ext cx="152400" cy="152400"/>
            </a:xfrm>
            <a:prstGeom prst="rect">
              <a:avLst/>
            </a:prstGeom>
            <a:solidFill>
              <a:srgbClr val="3333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4A7708C6-7334-4D20-AECE-8C59EAB423E8}"/>
                </a:ext>
              </a:extLst>
            </p:cNvPr>
            <p:cNvSpPr/>
            <p:nvPr/>
          </p:nvSpPr>
          <p:spPr>
            <a:xfrm>
              <a:off x="6576405" y="3118421"/>
              <a:ext cx="152400" cy="152400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5A631DE6-4F56-485D-BDA2-89B41F74FC87}"/>
                </a:ext>
              </a:extLst>
            </p:cNvPr>
            <p:cNvSpPr txBox="1"/>
            <p:nvPr/>
          </p:nvSpPr>
          <p:spPr>
            <a:xfrm>
              <a:off x="5275550" y="2292441"/>
              <a:ext cx="1321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ecretory Signal Peptide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77122AB3-B699-4E31-8495-4BBF6D32F44F}"/>
                </a:ext>
              </a:extLst>
            </p:cNvPr>
            <p:cNvSpPr txBox="1"/>
            <p:nvPr/>
          </p:nvSpPr>
          <p:spPr>
            <a:xfrm>
              <a:off x="5275550" y="2533004"/>
              <a:ext cx="6142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T-Als + 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3D6BAD10-97E9-45DE-8BBA-B3937CB27DD6}"/>
                </a:ext>
              </a:extLst>
            </p:cNvPr>
            <p:cNvSpPr txBox="1"/>
            <p:nvPr/>
          </p:nvSpPr>
          <p:spPr>
            <a:xfrm>
              <a:off x="5275550" y="2804871"/>
              <a:ext cx="11801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peated Sequences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9C6E7825-36E3-4C31-9FDF-7C6C07353111}"/>
                </a:ext>
              </a:extLst>
            </p:cNvPr>
            <p:cNvSpPr txBox="1"/>
            <p:nvPr/>
          </p:nvSpPr>
          <p:spPr>
            <a:xfrm>
              <a:off x="6766980" y="3089081"/>
              <a:ext cx="97174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PI Addition Site</a:t>
              </a: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84B325BC-23BA-42AC-A61B-F5BA8E08D919}"/>
                </a:ext>
              </a:extLst>
            </p:cNvPr>
            <p:cNvSpPr/>
            <p:nvPr/>
          </p:nvSpPr>
          <p:spPr>
            <a:xfrm>
              <a:off x="5055738" y="2778246"/>
              <a:ext cx="152400" cy="152400"/>
            </a:xfrm>
            <a:prstGeom prst="rect">
              <a:avLst/>
            </a:prstGeom>
            <a:solidFill>
              <a:srgbClr val="0099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AD3045DA-26B3-416D-B589-425D37751EEF}"/>
                </a:ext>
              </a:extLst>
            </p:cNvPr>
            <p:cNvSpPr/>
            <p:nvPr/>
          </p:nvSpPr>
          <p:spPr>
            <a:xfrm>
              <a:off x="4862443" y="2777635"/>
              <a:ext cx="152400" cy="152400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E2D503D4-FFBC-4F82-A622-5DE3F7798A70}"/>
                </a:ext>
              </a:extLst>
            </p:cNvPr>
            <p:cNvSpPr/>
            <p:nvPr/>
          </p:nvSpPr>
          <p:spPr>
            <a:xfrm>
              <a:off x="4969519" y="2967348"/>
              <a:ext cx="152400" cy="152400"/>
            </a:xfrm>
            <a:prstGeom prst="rect">
              <a:avLst/>
            </a:prstGeom>
            <a:solidFill>
              <a:srgbClr val="38572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57EE8AD8-682C-41DC-84B7-B4183DA35F7A}"/>
                </a:ext>
              </a:extLst>
            </p:cNvPr>
            <p:cNvSpPr txBox="1"/>
            <p:nvPr/>
          </p:nvSpPr>
          <p:spPr>
            <a:xfrm>
              <a:off x="6766980" y="2415770"/>
              <a:ext cx="6238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ST-Rich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A779600B-0180-4187-8503-86391BD8CA1E}"/>
                </a:ext>
              </a:extLst>
            </p:cNvPr>
            <p:cNvSpPr txBox="1"/>
            <p:nvPr/>
          </p:nvSpPr>
          <p:spPr>
            <a:xfrm>
              <a:off x="6766980" y="2628793"/>
              <a:ext cx="6928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PST-Rich</a:t>
              </a:r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5ECF92BC-1B3C-4809-BDF8-E31A98604542}"/>
                </a:ext>
              </a:extLst>
            </p:cNvPr>
            <p:cNvSpPr/>
            <p:nvPr/>
          </p:nvSpPr>
          <p:spPr>
            <a:xfrm>
              <a:off x="6576405" y="2887444"/>
              <a:ext cx="152400" cy="152400"/>
            </a:xfrm>
            <a:prstGeom prst="rect">
              <a:avLst/>
            </a:prstGeom>
            <a:solidFill>
              <a:srgbClr val="33669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F8F90BDD-99FE-40EB-A58D-DE7AE378FC14}"/>
                </a:ext>
              </a:extLst>
            </p:cNvPr>
            <p:cNvSpPr txBox="1"/>
            <p:nvPr/>
          </p:nvSpPr>
          <p:spPr>
            <a:xfrm>
              <a:off x="6766980" y="2859626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GS-Rich</a:t>
              </a: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A60E0FA3-0B4D-4DA5-964C-692F8AAF368C}"/>
                </a:ext>
              </a:extLst>
            </p:cNvPr>
            <p:cNvSpPr/>
            <p:nvPr/>
          </p:nvSpPr>
          <p:spPr>
            <a:xfrm>
              <a:off x="6576405" y="2194513"/>
              <a:ext cx="152400" cy="152400"/>
            </a:xfrm>
            <a:prstGeom prst="rect">
              <a:avLst/>
            </a:prstGeom>
            <a:solidFill>
              <a:srgbClr val="0066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2D344960-4AA2-4E59-A915-CBBBA36A0501}"/>
                </a:ext>
              </a:extLst>
            </p:cNvPr>
            <p:cNvSpPr txBox="1"/>
            <p:nvPr/>
          </p:nvSpPr>
          <p:spPr>
            <a:xfrm>
              <a:off x="6766980" y="2168505"/>
              <a:ext cx="7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er/Thr-Rich</a:t>
              </a: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4052B38A-2EA5-4146-8369-6C248E35A34F}"/>
                </a:ext>
              </a:extLst>
            </p:cNvPr>
            <p:cNvSpPr/>
            <p:nvPr/>
          </p:nvSpPr>
          <p:spPr>
            <a:xfrm>
              <a:off x="4771563" y="2967348"/>
              <a:ext cx="152400" cy="152400"/>
            </a:xfrm>
            <a:prstGeom prst="rect">
              <a:avLst/>
            </a:prstGeom>
            <a:solidFill>
              <a:srgbClr val="A9D18E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8D569C21-E241-454F-86CF-302C3CBAE115}"/>
                </a:ext>
              </a:extLst>
            </p:cNvPr>
            <p:cNvSpPr/>
            <p:nvPr/>
          </p:nvSpPr>
          <p:spPr>
            <a:xfrm>
              <a:off x="5168735" y="2967348"/>
              <a:ext cx="152400" cy="1524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800" dirty="0"/>
            </a:p>
          </p:txBody>
        </p:sp>
      </p:grpSp>
      <p:sp>
        <p:nvSpPr>
          <p:cNvPr id="152" name="TextBox 151">
            <a:extLst>
              <a:ext uri="{FF2B5EF4-FFF2-40B4-BE49-F238E27FC236}">
                <a16:creationId xmlns:a16="http://schemas.microsoft.com/office/drawing/2014/main" id="{339F0320-F529-4593-BE4A-0006C62B201A}"/>
              </a:ext>
            </a:extLst>
          </p:cNvPr>
          <p:cNvSpPr txBox="1"/>
          <p:nvPr/>
        </p:nvSpPr>
        <p:spPr>
          <a:xfrm>
            <a:off x="525945" y="62160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E9A8B4C2-FB7A-42C2-ACDB-5311A47FA03D}"/>
              </a:ext>
            </a:extLst>
          </p:cNvPr>
          <p:cNvSpPr txBox="1"/>
          <p:nvPr/>
        </p:nvSpPr>
        <p:spPr>
          <a:xfrm>
            <a:off x="565122" y="33339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C7850551-5BA4-41FE-B9CD-332566131064}"/>
              </a:ext>
            </a:extLst>
          </p:cNvPr>
          <p:cNvSpPr txBox="1"/>
          <p:nvPr/>
        </p:nvSpPr>
        <p:spPr>
          <a:xfrm>
            <a:off x="1337333" y="50656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0902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1186539-15B9-4DDE-A189-A5C18B4FEAFD}"/>
              </a:ext>
            </a:extLst>
          </p:cNvPr>
          <p:cNvSpPr txBox="1"/>
          <p:nvPr/>
        </p:nvSpPr>
        <p:spPr>
          <a:xfrm>
            <a:off x="698602" y="538584"/>
            <a:ext cx="729681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S11 |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feature summary for species with a single characterized gene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ine drawings to illustrate the basic features of the Als proteins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. tenu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lusitani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hanseni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glabrat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cerevisia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g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 color-coding key and scale bar are shown. The red region in each drawing corresponded to the NT-Als domain; the “+” designation referred to inclusion of sequences C-terminal to NT-Als (i.e. the red region ends where repeated sequences or Ser/Thr-rich sequences began). ClAls3274 had repeated units of several different lengths, with 33 and 67 amino acids appearing frequently enough to derive a consensus sequenc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shorter repeated sequence appeared unique in the NCBI non-redundant nucleotide database. The 67-amino acid sequence had elements of the sequence from Cp/Co/Cm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h et al., 20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resembled the 80-amino acid consensus repeated sequence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passalidar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shes were added to the sequences to improve alignment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cent identity values for comparisons among the NT-Als sequences for each protein calculated using Clustal Omega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deira et al., 20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3 was included for reference because its crystallographic structure is known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 et al., 201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4087375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1</TotalTime>
  <Words>517</Words>
  <Application>Microsoft Office PowerPoint</Application>
  <PresentationFormat>On-screen Show (4:3)</PresentationFormat>
  <Paragraphs>7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is Hoyer</dc:creator>
  <cp:lastModifiedBy>Lois Hoyer</cp:lastModifiedBy>
  <cp:revision>3</cp:revision>
  <dcterms:created xsi:type="dcterms:W3CDTF">2021-08-31T18:47:01Z</dcterms:created>
  <dcterms:modified xsi:type="dcterms:W3CDTF">2021-10-03T16:17:37Z</dcterms:modified>
</cp:coreProperties>
</file>